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6" r:id="rId2"/>
    <p:sldId id="258" r:id="rId3"/>
    <p:sldId id="259" r:id="rId4"/>
    <p:sldId id="265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E2E2"/>
    <a:srgbClr val="D9D9D9"/>
    <a:srgbClr val="FEEAFA"/>
    <a:srgbClr val="CBC0D3"/>
    <a:srgbClr val="DEE2FF"/>
    <a:srgbClr val="8E9AAF"/>
    <a:srgbClr val="CCBBCC"/>
    <a:srgbClr val="E8E8E8"/>
    <a:srgbClr val="EEEEEE"/>
    <a:srgbClr val="F3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70" d="100"/>
          <a:sy n="70" d="100"/>
        </p:scale>
        <p:origin x="84" y="444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03088F-1C20-4C90-8590-1F17DE22C1FA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B2DB6D-ECC8-470E-9D05-203AC198DAC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8385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B2DB6D-ECC8-470E-9D05-203AC198DAC5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6319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B2DB6D-ECC8-470E-9D05-203AC198DAC5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10792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B2DB6D-ECC8-470E-9D05-203AC198DAC5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188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6775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3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4952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744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8757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2160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792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2697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0513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904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3248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2BE4E-860B-4E4B-9F6D-B67E7712F237}" type="datetimeFigureOut">
              <a:rPr lang="de-DE" smtClean="0"/>
              <a:t>09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4F7DF-5A60-417B-997B-2AAA64162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3645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44.png"/><Relationship Id="rId18" Type="http://schemas.openxmlformats.org/officeDocument/2006/relationships/image" Target="../media/image49.png"/><Relationship Id="rId26" Type="http://schemas.openxmlformats.org/officeDocument/2006/relationships/image" Target="../media/image56.png"/><Relationship Id="rId3" Type="http://schemas.openxmlformats.org/officeDocument/2006/relationships/image" Target="../media/image38.png"/><Relationship Id="rId21" Type="http://schemas.openxmlformats.org/officeDocument/2006/relationships/image" Target="../media/image52.png"/><Relationship Id="rId7" Type="http://schemas.openxmlformats.org/officeDocument/2006/relationships/image" Target="../media/image41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5" Type="http://schemas.openxmlformats.org/officeDocument/2006/relationships/image" Target="../media/image5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7.png"/><Relationship Id="rId20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11" Type="http://schemas.openxmlformats.org/officeDocument/2006/relationships/image" Target="../media/image42.png"/><Relationship Id="rId24" Type="http://schemas.openxmlformats.org/officeDocument/2006/relationships/image" Target="../media/image54.png"/><Relationship Id="rId5" Type="http://schemas.openxmlformats.org/officeDocument/2006/relationships/image" Target="../media/image30.png"/><Relationship Id="rId15" Type="http://schemas.openxmlformats.org/officeDocument/2006/relationships/image" Target="../media/image46.png"/><Relationship Id="rId23" Type="http://schemas.openxmlformats.org/officeDocument/2006/relationships/image" Target="../media/image53.png"/><Relationship Id="rId28" Type="http://schemas.openxmlformats.org/officeDocument/2006/relationships/image" Target="../media/image57.png"/><Relationship Id="rId10" Type="http://schemas.openxmlformats.org/officeDocument/2006/relationships/image" Target="../media/image35.png"/><Relationship Id="rId19" Type="http://schemas.openxmlformats.org/officeDocument/2006/relationships/image" Target="../media/image50.png"/><Relationship Id="rId4" Type="http://schemas.openxmlformats.org/officeDocument/2006/relationships/image" Target="../media/image39.png"/><Relationship Id="rId9" Type="http://schemas.openxmlformats.org/officeDocument/2006/relationships/image" Target="../media/image34.png"/><Relationship Id="rId14" Type="http://schemas.openxmlformats.org/officeDocument/2006/relationships/image" Target="../media/image45.png"/><Relationship Id="rId22" Type="http://schemas.openxmlformats.org/officeDocument/2006/relationships/image" Target="../media/image28.png"/><Relationship Id="rId27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openxmlformats.org/officeDocument/2006/relationships/image" Target="../media/image67.png"/><Relationship Id="rId18" Type="http://schemas.openxmlformats.org/officeDocument/2006/relationships/image" Target="../media/image72.png"/><Relationship Id="rId3" Type="http://schemas.openxmlformats.org/officeDocument/2006/relationships/image" Target="../media/image58.png"/><Relationship Id="rId21" Type="http://schemas.openxmlformats.org/officeDocument/2006/relationships/image" Target="../media/image49.png"/><Relationship Id="rId7" Type="http://schemas.openxmlformats.org/officeDocument/2006/relationships/image" Target="../media/image62.png"/><Relationship Id="rId12" Type="http://schemas.openxmlformats.org/officeDocument/2006/relationships/image" Target="../media/image66.png"/><Relationship Id="rId17" Type="http://schemas.openxmlformats.org/officeDocument/2006/relationships/image" Target="../media/image7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70.png"/><Relationship Id="rId20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11" Type="http://schemas.openxmlformats.org/officeDocument/2006/relationships/image" Target="../media/image65.png"/><Relationship Id="rId5" Type="http://schemas.openxmlformats.org/officeDocument/2006/relationships/image" Target="../media/image60.png"/><Relationship Id="rId15" Type="http://schemas.openxmlformats.org/officeDocument/2006/relationships/image" Target="../media/image69.png"/><Relationship Id="rId10" Type="http://schemas.openxmlformats.org/officeDocument/2006/relationships/image" Target="../media/image64.png"/><Relationship Id="rId19" Type="http://schemas.openxmlformats.org/officeDocument/2006/relationships/image" Target="../media/image73.png"/><Relationship Id="rId4" Type="http://schemas.openxmlformats.org/officeDocument/2006/relationships/image" Target="../media/image59.png"/><Relationship Id="rId9" Type="http://schemas.openxmlformats.org/officeDocument/2006/relationships/image" Target="../media/image8.png"/><Relationship Id="rId14" Type="http://schemas.openxmlformats.org/officeDocument/2006/relationships/image" Target="../media/image6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7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8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5" Type="http://schemas.openxmlformats.org/officeDocument/2006/relationships/image" Target="../media/image76.png"/><Relationship Id="rId15" Type="http://schemas.openxmlformats.org/officeDocument/2006/relationships/image" Target="../media/image85.png"/><Relationship Id="rId10" Type="http://schemas.openxmlformats.org/officeDocument/2006/relationships/image" Target="../media/image81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png"/><Relationship Id="rId13" Type="http://schemas.microsoft.com/office/2007/relationships/hdphoto" Target="../media/hdphoto2.wdp"/><Relationship Id="rId18" Type="http://schemas.openxmlformats.org/officeDocument/2006/relationships/image" Target="../media/image103.png"/><Relationship Id="rId3" Type="http://schemas.openxmlformats.org/officeDocument/2006/relationships/image" Target="../media/image89.png"/><Relationship Id="rId21" Type="http://schemas.openxmlformats.org/officeDocument/2006/relationships/image" Target="../media/image106.png"/><Relationship Id="rId7" Type="http://schemas.openxmlformats.org/officeDocument/2006/relationships/image" Target="../media/image93.png"/><Relationship Id="rId12" Type="http://schemas.openxmlformats.org/officeDocument/2006/relationships/image" Target="../media/image98.png"/><Relationship Id="rId17" Type="http://schemas.openxmlformats.org/officeDocument/2006/relationships/image" Target="../media/image102.png"/><Relationship Id="rId2" Type="http://schemas.openxmlformats.org/officeDocument/2006/relationships/image" Target="../media/image88.png"/><Relationship Id="rId16" Type="http://schemas.openxmlformats.org/officeDocument/2006/relationships/image" Target="../media/image101.png"/><Relationship Id="rId20" Type="http://schemas.openxmlformats.org/officeDocument/2006/relationships/image" Target="../media/image10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2.png"/><Relationship Id="rId11" Type="http://schemas.openxmlformats.org/officeDocument/2006/relationships/image" Target="../media/image97.png"/><Relationship Id="rId5" Type="http://schemas.openxmlformats.org/officeDocument/2006/relationships/image" Target="../media/image91.png"/><Relationship Id="rId15" Type="http://schemas.openxmlformats.org/officeDocument/2006/relationships/image" Target="../media/image100.png"/><Relationship Id="rId10" Type="http://schemas.openxmlformats.org/officeDocument/2006/relationships/image" Target="../media/image96.png"/><Relationship Id="rId19" Type="http://schemas.openxmlformats.org/officeDocument/2006/relationships/image" Target="../media/image104.png"/><Relationship Id="rId4" Type="http://schemas.openxmlformats.org/officeDocument/2006/relationships/image" Target="../media/image90.png"/><Relationship Id="rId9" Type="http://schemas.openxmlformats.org/officeDocument/2006/relationships/image" Target="../media/image95.png"/><Relationship Id="rId14" Type="http://schemas.openxmlformats.org/officeDocument/2006/relationships/image" Target="../media/image9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png"/><Relationship Id="rId13" Type="http://schemas.microsoft.com/office/2007/relationships/hdphoto" Target="../media/hdphoto3.wdp"/><Relationship Id="rId18" Type="http://schemas.openxmlformats.org/officeDocument/2006/relationships/image" Target="../media/image121.png"/><Relationship Id="rId3" Type="http://schemas.openxmlformats.org/officeDocument/2006/relationships/image" Target="../media/image108.png"/><Relationship Id="rId7" Type="http://schemas.openxmlformats.org/officeDocument/2006/relationships/image" Target="../media/image111.png"/><Relationship Id="rId12" Type="http://schemas.openxmlformats.org/officeDocument/2006/relationships/image" Target="../media/image116.png"/><Relationship Id="rId17" Type="http://schemas.openxmlformats.org/officeDocument/2006/relationships/image" Target="../media/image120.png"/><Relationship Id="rId2" Type="http://schemas.openxmlformats.org/officeDocument/2006/relationships/image" Target="../media/image107.png"/><Relationship Id="rId16" Type="http://schemas.openxmlformats.org/officeDocument/2006/relationships/image" Target="../media/image1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png"/><Relationship Id="rId11" Type="http://schemas.openxmlformats.org/officeDocument/2006/relationships/image" Target="../media/image115.png"/><Relationship Id="rId5" Type="http://schemas.openxmlformats.org/officeDocument/2006/relationships/image" Target="../media/image109.png"/><Relationship Id="rId15" Type="http://schemas.openxmlformats.org/officeDocument/2006/relationships/image" Target="../media/image118.png"/><Relationship Id="rId10" Type="http://schemas.openxmlformats.org/officeDocument/2006/relationships/image" Target="../media/image114.png"/><Relationship Id="rId4" Type="http://schemas.openxmlformats.org/officeDocument/2006/relationships/image" Target="../media/image27.png"/><Relationship Id="rId9" Type="http://schemas.openxmlformats.org/officeDocument/2006/relationships/image" Target="../media/image113.png"/><Relationship Id="rId14" Type="http://schemas.openxmlformats.org/officeDocument/2006/relationships/image" Target="../media/image11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8.png"/><Relationship Id="rId13" Type="http://schemas.openxmlformats.org/officeDocument/2006/relationships/image" Target="../media/image133.png"/><Relationship Id="rId3" Type="http://schemas.openxmlformats.org/officeDocument/2006/relationships/image" Target="../media/image123.png"/><Relationship Id="rId7" Type="http://schemas.openxmlformats.org/officeDocument/2006/relationships/image" Target="../media/image127.png"/><Relationship Id="rId12" Type="http://schemas.openxmlformats.org/officeDocument/2006/relationships/image" Target="../media/image132.png"/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6.png"/><Relationship Id="rId11" Type="http://schemas.openxmlformats.org/officeDocument/2006/relationships/image" Target="../media/image131.png"/><Relationship Id="rId5" Type="http://schemas.openxmlformats.org/officeDocument/2006/relationships/image" Target="../media/image125.png"/><Relationship Id="rId10" Type="http://schemas.openxmlformats.org/officeDocument/2006/relationships/image" Target="../media/image130.png"/><Relationship Id="rId4" Type="http://schemas.openxmlformats.org/officeDocument/2006/relationships/image" Target="../media/image124.png"/><Relationship Id="rId9" Type="http://schemas.openxmlformats.org/officeDocument/2006/relationships/image" Target="../media/image129.png"/><Relationship Id="rId14" Type="http://schemas.openxmlformats.org/officeDocument/2006/relationships/image" Target="../media/image134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13" Type="http://schemas.openxmlformats.org/officeDocument/2006/relationships/image" Target="../media/image145.png"/><Relationship Id="rId18" Type="http://schemas.openxmlformats.org/officeDocument/2006/relationships/image" Target="../media/image150.png"/><Relationship Id="rId3" Type="http://schemas.openxmlformats.org/officeDocument/2006/relationships/image" Target="../media/image136.png"/><Relationship Id="rId21" Type="http://schemas.openxmlformats.org/officeDocument/2006/relationships/image" Target="../media/image153.png"/><Relationship Id="rId7" Type="http://schemas.openxmlformats.org/officeDocument/2006/relationships/image" Target="../media/image140.png"/><Relationship Id="rId12" Type="http://schemas.openxmlformats.org/officeDocument/2006/relationships/image" Target="../media/image144.png"/><Relationship Id="rId17" Type="http://schemas.openxmlformats.org/officeDocument/2006/relationships/image" Target="../media/image149.png"/><Relationship Id="rId2" Type="http://schemas.openxmlformats.org/officeDocument/2006/relationships/image" Target="../media/image135.png"/><Relationship Id="rId16" Type="http://schemas.openxmlformats.org/officeDocument/2006/relationships/image" Target="../media/image148.png"/><Relationship Id="rId20" Type="http://schemas.openxmlformats.org/officeDocument/2006/relationships/image" Target="../media/image1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9.png"/><Relationship Id="rId11" Type="http://schemas.openxmlformats.org/officeDocument/2006/relationships/image" Target="../media/image143.png"/><Relationship Id="rId5" Type="http://schemas.openxmlformats.org/officeDocument/2006/relationships/image" Target="../media/image138.png"/><Relationship Id="rId15" Type="http://schemas.openxmlformats.org/officeDocument/2006/relationships/image" Target="../media/image147.png"/><Relationship Id="rId23" Type="http://schemas.openxmlformats.org/officeDocument/2006/relationships/image" Target="../media/image155.png"/><Relationship Id="rId10" Type="http://schemas.openxmlformats.org/officeDocument/2006/relationships/image" Target="../media/image142.png"/><Relationship Id="rId19" Type="http://schemas.openxmlformats.org/officeDocument/2006/relationships/image" Target="../media/image151.png"/><Relationship Id="rId4" Type="http://schemas.openxmlformats.org/officeDocument/2006/relationships/image" Target="../media/image137.png"/><Relationship Id="rId9" Type="http://schemas.openxmlformats.org/officeDocument/2006/relationships/image" Target="../media/image141.png"/><Relationship Id="rId14" Type="http://schemas.openxmlformats.org/officeDocument/2006/relationships/image" Target="../media/image146.png"/><Relationship Id="rId22" Type="http://schemas.openxmlformats.org/officeDocument/2006/relationships/image" Target="../media/image1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9643" y="137936"/>
            <a:ext cx="11678440" cy="6601531"/>
            <a:chOff x="818291" y="47625"/>
            <a:chExt cx="11232682" cy="6248400"/>
          </a:xfrm>
        </p:grpSpPr>
        <p:sp>
          <p:nvSpPr>
            <p:cNvPr id="24" name="Rounded Rectangle 23"/>
            <p:cNvSpPr/>
            <p:nvPr/>
          </p:nvSpPr>
          <p:spPr>
            <a:xfrm>
              <a:off x="818291" y="47625"/>
              <a:ext cx="11232682" cy="6248400"/>
            </a:xfrm>
            <a:prstGeom prst="roundRect">
              <a:avLst>
                <a:gd name="adj" fmla="val 3819"/>
              </a:avLst>
            </a:prstGeom>
            <a:solidFill>
              <a:srgbClr val="D9D9D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8277629" y="266700"/>
              <a:ext cx="1777913" cy="5769733"/>
            </a:xfrm>
            <a:prstGeom prst="rect">
              <a:avLst/>
            </a:prstGeom>
            <a:solidFill>
              <a:srgbClr val="E2E2E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u="sng"/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3305424" y="269117"/>
              <a:ext cx="3424735" cy="576973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u="sng"/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10057365" y="266701"/>
              <a:ext cx="1565112" cy="57697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u="sng"/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6701311" y="266701"/>
              <a:ext cx="1584043" cy="5772149"/>
            </a:xfrm>
            <a:prstGeom prst="rect">
              <a:avLst/>
            </a:prstGeom>
            <a:solidFill>
              <a:srgbClr val="E8E8E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u="sng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1071453" y="266701"/>
              <a:ext cx="2250389" cy="57697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u="sng"/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1049974" y="3797027"/>
              <a:ext cx="2086681" cy="1491769"/>
              <a:chOff x="-74394" y="4194447"/>
              <a:chExt cx="2422873" cy="1772399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1742" y="4194447"/>
                <a:ext cx="1356737" cy="1419617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74394" y="4526432"/>
                <a:ext cx="1317093" cy="1378135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7469" y="4464154"/>
                <a:ext cx="1436133" cy="1502692"/>
              </a:xfrm>
              <a:prstGeom prst="rect">
                <a:avLst/>
              </a:prstGeom>
            </p:spPr>
          </p:pic>
        </p:grpSp>
        <p:grpSp>
          <p:nvGrpSpPr>
            <p:cNvPr id="35" name="Group 34"/>
            <p:cNvGrpSpPr/>
            <p:nvPr/>
          </p:nvGrpSpPr>
          <p:grpSpPr>
            <a:xfrm>
              <a:off x="1439638" y="4927690"/>
              <a:ext cx="1722594" cy="866917"/>
              <a:chOff x="398998" y="5554436"/>
              <a:chExt cx="2000126" cy="1030000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14746" y="5554436"/>
                <a:ext cx="984378" cy="1030000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8998" y="5733943"/>
                <a:ext cx="641265" cy="670985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40263" y="5839212"/>
                <a:ext cx="440052" cy="460447"/>
              </a:xfrm>
              <a:prstGeom prst="rect">
                <a:avLst/>
              </a:prstGeom>
            </p:spPr>
          </p:pic>
        </p:grpSp>
        <p:sp>
          <p:nvSpPr>
            <p:cNvPr id="71" name="TextBox 70"/>
            <p:cNvSpPr txBox="1"/>
            <p:nvPr/>
          </p:nvSpPr>
          <p:spPr>
            <a:xfrm>
              <a:off x="1177369" y="441772"/>
              <a:ext cx="19430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linical </a:t>
              </a:r>
              <a:r>
                <a:rPr lang="de-DE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trial</a:t>
              </a:r>
              <a:endPara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568707" y="2260898"/>
              <a:ext cx="13642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Research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cope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300552" y="3630485"/>
              <a:ext cx="19578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ubject</a:t>
              </a:r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cquisition</a:t>
              </a:r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&amp;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trial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428226" y="5546430"/>
              <a:ext cx="15449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re-analytics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102" name="Group 101"/>
            <p:cNvGrpSpPr/>
            <p:nvPr/>
          </p:nvGrpSpPr>
          <p:grpSpPr>
            <a:xfrm>
              <a:off x="6749805" y="2822395"/>
              <a:ext cx="1528330" cy="1033345"/>
              <a:chOff x="7101892" y="3105331"/>
              <a:chExt cx="1680601" cy="1172859"/>
            </a:xfrm>
          </p:grpSpPr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01892" y="3120350"/>
                <a:ext cx="1106556" cy="1157840"/>
              </a:xfrm>
              <a:prstGeom prst="rect">
                <a:avLst/>
              </a:prstGeom>
            </p:spPr>
          </p:pic>
          <p:pic>
            <p:nvPicPr>
              <p:cNvPr id="55" name="Picture 54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85198" y="3105331"/>
                <a:ext cx="1097295" cy="1148150"/>
              </a:xfrm>
              <a:prstGeom prst="rect">
                <a:avLst/>
              </a:prstGeom>
            </p:spPr>
          </p:pic>
        </p:grpSp>
        <p:sp>
          <p:nvSpPr>
            <p:cNvPr id="74" name="TextBox 73"/>
            <p:cNvSpPr txBox="1"/>
            <p:nvPr/>
          </p:nvSpPr>
          <p:spPr>
            <a:xfrm>
              <a:off x="6636788" y="367685"/>
              <a:ext cx="175436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Data Processing</a:t>
              </a:r>
              <a:endPara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828608" y="2368977"/>
              <a:ext cx="137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eak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integration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6844572" y="3820698"/>
              <a:ext cx="12934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eak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valuation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6917043" y="5243646"/>
              <a:ext cx="1193855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Imputation</a:t>
              </a:r>
              <a:endParaRPr lang="de-DE" sz="11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Normalization</a:t>
              </a:r>
              <a:endParaRPr lang="de-DE" sz="11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caling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39736" y="867353"/>
              <a:ext cx="1455748" cy="1422659"/>
            </a:xfrm>
            <a:prstGeom prst="rect">
              <a:avLst/>
            </a:prstGeom>
          </p:spPr>
        </p:pic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12244" y="2094864"/>
              <a:ext cx="1024879" cy="1001583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>
              <a:off x="8400480" y="363296"/>
              <a:ext cx="1496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Data Analysis</a:t>
              </a:r>
              <a:endPara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8385996" y="3292817"/>
              <a:ext cx="1566935" cy="1218414"/>
              <a:chOff x="8440093" y="3595386"/>
              <a:chExt cx="1819389" cy="1447621"/>
            </a:xfrm>
          </p:grpSpPr>
          <p:pic>
            <p:nvPicPr>
              <p:cNvPr id="61" name="Picture 60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91618" y="3595386"/>
                <a:ext cx="1254370" cy="1254370"/>
              </a:xfrm>
              <a:prstGeom prst="rect">
                <a:avLst/>
              </a:prstGeom>
            </p:spPr>
          </p:pic>
          <p:sp>
            <p:nvSpPr>
              <p:cNvPr id="90" name="TextBox 89"/>
              <p:cNvSpPr txBox="1"/>
              <p:nvPr/>
            </p:nvSpPr>
            <p:spPr>
              <a:xfrm>
                <a:off x="8440093" y="4732183"/>
                <a:ext cx="1819389" cy="3108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100" dirty="0" err="1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Machine</a:t>
                </a:r>
                <a:r>
                  <a:rPr lang="de-DE" sz="11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 </a:t>
                </a:r>
                <a:r>
                  <a:rPr lang="de-DE" sz="1100" dirty="0" err="1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learning</a:t>
                </a:r>
                <a:endParaRPr lang="de-DE" sz="11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</p:grpSp>
        <p:sp>
          <p:nvSpPr>
            <p:cNvPr id="91" name="TextBox 90"/>
            <p:cNvSpPr txBox="1"/>
            <p:nvPr/>
          </p:nvSpPr>
          <p:spPr>
            <a:xfrm>
              <a:off x="8377013" y="3065282"/>
              <a:ext cx="15669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lassical</a:t>
              </a:r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tatistics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8369854" y="5572304"/>
              <a:ext cx="15669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linical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translation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8077" y="1968624"/>
              <a:ext cx="1456297" cy="1423196"/>
            </a:xfrm>
            <a:prstGeom prst="rect">
              <a:avLst/>
            </a:prstGeom>
          </p:spPr>
        </p:pic>
        <p:sp>
          <p:nvSpPr>
            <p:cNvPr id="80" name="TextBox 79"/>
            <p:cNvSpPr txBox="1"/>
            <p:nvPr/>
          </p:nvSpPr>
          <p:spPr>
            <a:xfrm>
              <a:off x="3339634" y="3337368"/>
              <a:ext cx="34182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iobanking &amp;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nalyte</a:t>
              </a:r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xtraction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3123991" y="3615971"/>
              <a:ext cx="3548347" cy="2241817"/>
              <a:chOff x="2477953" y="3931511"/>
              <a:chExt cx="4314422" cy="2797747"/>
            </a:xfrm>
          </p:grpSpPr>
          <p:sp>
            <p:nvSpPr>
              <p:cNvPr id="84" name="TextBox 83"/>
              <p:cNvSpPr txBox="1"/>
              <p:nvPr/>
            </p:nvSpPr>
            <p:spPr>
              <a:xfrm>
                <a:off x="5200062" y="6316728"/>
                <a:ext cx="1112113" cy="3264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err="1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Detection</a:t>
                </a:r>
                <a:endParaRPr lang="de-DE" sz="11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  <p:grpSp>
            <p:nvGrpSpPr>
              <p:cNvPr id="69" name="Group 68"/>
              <p:cNvGrpSpPr/>
              <p:nvPr/>
            </p:nvGrpSpPr>
            <p:grpSpPr>
              <a:xfrm>
                <a:off x="2477953" y="3931511"/>
                <a:ext cx="4314422" cy="2586976"/>
                <a:chOff x="2479692" y="4096959"/>
                <a:chExt cx="4314422" cy="2586976"/>
              </a:xfrm>
            </p:grpSpPr>
            <p:pic>
              <p:nvPicPr>
                <p:cNvPr id="42" name="Picture 41"/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82753" y="4472574"/>
                  <a:ext cx="2211361" cy="2211361"/>
                </a:xfrm>
                <a:prstGeom prst="rect">
                  <a:avLst/>
                </a:prstGeom>
              </p:spPr>
            </p:pic>
            <p:pic>
              <p:nvPicPr>
                <p:cNvPr id="41" name="Picture 40"/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79692" y="4451896"/>
                  <a:ext cx="1898007" cy="1898007"/>
                </a:xfrm>
                <a:prstGeom prst="rect">
                  <a:avLst/>
                </a:prstGeom>
              </p:spPr>
            </p:pic>
            <p:grpSp>
              <p:nvGrpSpPr>
                <p:cNvPr id="68" name="Group 67"/>
                <p:cNvGrpSpPr/>
                <p:nvPr/>
              </p:nvGrpSpPr>
              <p:grpSpPr>
                <a:xfrm>
                  <a:off x="3545622" y="4096959"/>
                  <a:ext cx="1510284" cy="2400391"/>
                  <a:chOff x="3545622" y="4096959"/>
                  <a:chExt cx="1510284" cy="2400391"/>
                </a:xfrm>
              </p:grpSpPr>
              <p:pic>
                <p:nvPicPr>
                  <p:cNvPr id="43" name="Picture 42"/>
                  <p:cNvPicPr>
                    <a:picLocks noChangeAspect="1"/>
                  </p:cNvPicPr>
                  <p:nvPr/>
                </p:nvPicPr>
                <p:blipFill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rot="3307623">
                    <a:off x="3511808" y="5004349"/>
                    <a:ext cx="1526815" cy="1459187"/>
                  </a:xfrm>
                  <a:prstGeom prst="rect">
                    <a:avLst/>
                  </a:prstGeom>
                </p:spPr>
              </p:pic>
              <p:grpSp>
                <p:nvGrpSpPr>
                  <p:cNvPr id="22" name="Group 21"/>
                  <p:cNvGrpSpPr/>
                  <p:nvPr/>
                </p:nvGrpSpPr>
                <p:grpSpPr>
                  <a:xfrm>
                    <a:off x="3849552" y="4096959"/>
                    <a:ext cx="683615" cy="748558"/>
                    <a:chOff x="4247223" y="4229059"/>
                    <a:chExt cx="683615" cy="748558"/>
                  </a:xfrm>
                </p:grpSpPr>
                <p:pic>
                  <p:nvPicPr>
                    <p:cNvPr id="44" name="Picture 43"/>
                    <p:cNvPicPr>
                      <a:picLocks noChangeAspect="1"/>
                    </p:cNvPicPr>
                    <p:nvPr/>
                  </p:nvPicPr>
                  <p:blipFill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247223" y="4445296"/>
                      <a:ext cx="508743" cy="5323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9" name="Picture 48"/>
                    <p:cNvPicPr>
                      <a:picLocks noChangeAspect="1"/>
                    </p:cNvPicPr>
                    <p:nvPr/>
                  </p:nvPicPr>
                  <p:blipFill>
                    <a:blip r:embed="rId1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482824" y="4229059"/>
                      <a:ext cx="448014" cy="468777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26" name="Group 25"/>
                  <p:cNvGrpSpPr/>
                  <p:nvPr/>
                </p:nvGrpSpPr>
                <p:grpSpPr>
                  <a:xfrm>
                    <a:off x="4103894" y="4564114"/>
                    <a:ext cx="683615" cy="751864"/>
                    <a:chOff x="4247223" y="4852580"/>
                    <a:chExt cx="683615" cy="751864"/>
                  </a:xfrm>
                </p:grpSpPr>
                <p:pic>
                  <p:nvPicPr>
                    <p:cNvPr id="45" name="Picture 44"/>
                    <p:cNvPicPr>
                      <a:picLocks noChangeAspect="1"/>
                    </p:cNvPicPr>
                    <p:nvPr/>
                  </p:nvPicPr>
                  <p:blipFill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247223" y="5072123"/>
                      <a:ext cx="508743" cy="5323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0" name="Picture 49"/>
                    <p:cNvPicPr>
                      <a:picLocks noChangeAspect="1"/>
                    </p:cNvPicPr>
                    <p:nvPr/>
                  </p:nvPicPr>
                  <p:blipFill>
                    <a:blip r:embed="rId1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482824" y="4852580"/>
                      <a:ext cx="448014" cy="468777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4372291" y="5128983"/>
                    <a:ext cx="683615" cy="651389"/>
                    <a:chOff x="4247223" y="5538189"/>
                    <a:chExt cx="683615" cy="651389"/>
                  </a:xfrm>
                </p:grpSpPr>
                <p:pic>
                  <p:nvPicPr>
                    <p:cNvPr id="46" name="Picture 45"/>
                    <p:cNvPicPr>
                      <a:picLocks noChangeAspect="1"/>
                    </p:cNvPicPr>
                    <p:nvPr/>
                  </p:nvPicPr>
                  <p:blipFill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247223" y="5657257"/>
                      <a:ext cx="508743" cy="5323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1" name="Picture 50"/>
                    <p:cNvPicPr>
                      <a:picLocks noChangeAspect="1"/>
                    </p:cNvPicPr>
                    <p:nvPr/>
                  </p:nvPicPr>
                  <p:blipFill>
                    <a:blip r:embed="rId2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482824" y="5538189"/>
                      <a:ext cx="448014" cy="468777"/>
                    </a:xfrm>
                    <a:prstGeom prst="rect">
                      <a:avLst/>
                    </a:prstGeom>
                  </p:spPr>
                </p:pic>
              </p:grpSp>
            </p:grpSp>
          </p:grpSp>
          <p:sp>
            <p:nvSpPr>
              <p:cNvPr id="82" name="TextBox 81"/>
              <p:cNvSpPr txBox="1"/>
              <p:nvPr/>
            </p:nvSpPr>
            <p:spPr>
              <a:xfrm>
                <a:off x="2866125" y="6191519"/>
                <a:ext cx="1196736" cy="537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Separation </a:t>
                </a:r>
              </a:p>
              <a:p>
                <a:r>
                  <a:rPr lang="de-DE" sz="1100" dirty="0" err="1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of</a:t>
                </a:r>
                <a:r>
                  <a:rPr lang="de-DE" sz="11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 </a:t>
                </a:r>
                <a:r>
                  <a:rPr lang="de-DE" sz="1100" dirty="0" err="1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analytes</a:t>
                </a:r>
                <a:endParaRPr lang="de-DE" sz="11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</p:grpSp>
        <p:grpSp>
          <p:nvGrpSpPr>
            <p:cNvPr id="103" name="Group 102"/>
            <p:cNvGrpSpPr/>
            <p:nvPr/>
          </p:nvGrpSpPr>
          <p:grpSpPr>
            <a:xfrm>
              <a:off x="8314602" y="4201903"/>
              <a:ext cx="1768496" cy="1440441"/>
              <a:chOff x="8245204" y="4875502"/>
              <a:chExt cx="2053424" cy="1711415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68226" y="4875502"/>
                <a:ext cx="1533980" cy="1605073"/>
              </a:xfrm>
              <a:prstGeom prst="rect">
                <a:avLst/>
              </a:prstGeom>
            </p:spPr>
          </p:pic>
          <p:pic>
            <p:nvPicPr>
              <p:cNvPr id="64" name="Picture 63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45204" y="6120091"/>
                <a:ext cx="376719" cy="394178"/>
              </a:xfrm>
              <a:prstGeom prst="rect">
                <a:avLst/>
              </a:prstGeom>
            </p:spPr>
          </p:pic>
          <p:pic>
            <p:nvPicPr>
              <p:cNvPr id="66" name="Picture 65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43513" y="6133648"/>
                <a:ext cx="376719" cy="394178"/>
              </a:xfrm>
              <a:prstGeom prst="rect">
                <a:avLst/>
              </a:prstGeom>
            </p:spPr>
          </p:pic>
          <p:pic>
            <p:nvPicPr>
              <p:cNvPr id="95" name="Picture 94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223313" y="5653265"/>
                <a:ext cx="1075315" cy="933652"/>
              </a:xfrm>
              <a:prstGeom prst="rect">
                <a:avLst/>
              </a:prstGeom>
            </p:spPr>
          </p:pic>
        </p:grpSp>
        <p:sp>
          <p:nvSpPr>
            <p:cNvPr id="93" name="TextBox 92"/>
            <p:cNvSpPr txBox="1"/>
            <p:nvPr/>
          </p:nvSpPr>
          <p:spPr>
            <a:xfrm>
              <a:off x="10151618" y="441772"/>
              <a:ext cx="1496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QM/QA</a:t>
              </a:r>
              <a:endPara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6754774" y="1043668"/>
              <a:ext cx="1518394" cy="1203754"/>
              <a:chOff x="4911671" y="158725"/>
              <a:chExt cx="3589775" cy="2917371"/>
            </a:xfrm>
          </p:grpSpPr>
          <p:pic>
            <p:nvPicPr>
              <p:cNvPr id="97" name="Picture 96"/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11671" y="158725"/>
                <a:ext cx="2527235" cy="2527235"/>
              </a:xfrm>
              <a:prstGeom prst="rect">
                <a:avLst/>
              </a:prstGeom>
            </p:spPr>
          </p:pic>
          <p:pic>
            <p:nvPicPr>
              <p:cNvPr id="98" name="Picture 97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20323" y="681240"/>
                <a:ext cx="2781123" cy="2394856"/>
              </a:xfrm>
              <a:prstGeom prst="rect">
                <a:avLst/>
              </a:prstGeom>
            </p:spPr>
          </p:pic>
        </p:grpSp>
        <p:grpSp>
          <p:nvGrpSpPr>
            <p:cNvPr id="104" name="Group 103"/>
            <p:cNvGrpSpPr/>
            <p:nvPr/>
          </p:nvGrpSpPr>
          <p:grpSpPr>
            <a:xfrm>
              <a:off x="9908151" y="842745"/>
              <a:ext cx="1595493" cy="5077487"/>
              <a:chOff x="10341233" y="767988"/>
              <a:chExt cx="1852548" cy="6032659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14" r="31773"/>
              <a:stretch/>
            </p:blipFill>
            <p:spPr>
              <a:xfrm>
                <a:off x="10685624" y="767988"/>
                <a:ext cx="1508157" cy="5929212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341233" y="5548966"/>
                <a:ext cx="1453565" cy="1251681"/>
              </a:xfrm>
              <a:prstGeom prst="rect">
                <a:avLst/>
              </a:prstGeom>
            </p:spPr>
          </p:pic>
        </p:grpSp>
        <p:pic>
          <p:nvPicPr>
            <p:cNvPr id="99" name="Picture 98"/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198"/>
            <a:stretch/>
          </p:blipFill>
          <p:spPr>
            <a:xfrm>
              <a:off x="6723443" y="4089428"/>
              <a:ext cx="1581056" cy="1209861"/>
            </a:xfrm>
            <a:prstGeom prst="rect">
              <a:avLst/>
            </a:prstGeom>
          </p:spPr>
        </p:pic>
        <p:grpSp>
          <p:nvGrpSpPr>
            <p:cNvPr id="58" name="Group 57"/>
            <p:cNvGrpSpPr/>
            <p:nvPr/>
          </p:nvGrpSpPr>
          <p:grpSpPr>
            <a:xfrm>
              <a:off x="1522879" y="2482805"/>
              <a:ext cx="1599070" cy="1172887"/>
              <a:chOff x="386315" y="2632995"/>
              <a:chExt cx="1856701" cy="1393529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386315" y="2632995"/>
                <a:ext cx="1316494" cy="1192614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4520" y="2753375"/>
                <a:ext cx="1478496" cy="1273149"/>
              </a:xfrm>
              <a:prstGeom prst="rect">
                <a:avLst/>
              </a:prstGeom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961151" y="605066"/>
              <a:ext cx="2414097" cy="1678205"/>
              <a:chOff x="-351849" y="418787"/>
              <a:chExt cx="2803039" cy="1993907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151852" y="418787"/>
                <a:ext cx="1776235" cy="1858557"/>
                <a:chOff x="194084" y="550481"/>
                <a:chExt cx="2158591" cy="2158591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3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4084" y="550481"/>
                  <a:ext cx="2158591" cy="2158591"/>
                </a:xfrm>
                <a:prstGeom prst="rect">
                  <a:avLst/>
                </a:prstGeom>
              </p:spPr>
            </p:pic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>
                <a:blip r:embed="rId3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06703" y="1103360"/>
                  <a:ext cx="763539" cy="763539"/>
                </a:xfrm>
                <a:prstGeom prst="rect">
                  <a:avLst/>
                </a:prstGeom>
              </p:spPr>
            </p:pic>
          </p:grpSp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0557" y="1002076"/>
                <a:ext cx="1331961" cy="1146967"/>
              </a:xfrm>
              <a:prstGeom prst="rect">
                <a:avLst/>
              </a:prstGeom>
            </p:spPr>
          </p:pic>
          <p:pic>
            <p:nvPicPr>
              <p:cNvPr id="47" name="Picture 46"/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-80917" y="1015146"/>
                <a:ext cx="1379174" cy="1194045"/>
              </a:xfrm>
              <a:prstGeom prst="rect">
                <a:avLst/>
              </a:prstGeom>
            </p:spPr>
          </p:pic>
          <p:pic>
            <p:nvPicPr>
              <p:cNvPr id="48" name="Picture 47"/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22764" y="1302188"/>
                <a:ext cx="1228426" cy="1057811"/>
              </a:xfrm>
              <a:prstGeom prst="rect">
                <a:avLst/>
              </a:prstGeom>
            </p:spPr>
          </p:pic>
          <p:grpSp>
            <p:nvGrpSpPr>
              <p:cNvPr id="18" name="Group 17"/>
              <p:cNvGrpSpPr/>
              <p:nvPr/>
            </p:nvGrpSpPr>
            <p:grpSpPr>
              <a:xfrm>
                <a:off x="-351849" y="1291944"/>
                <a:ext cx="1256187" cy="1120750"/>
                <a:chOff x="-351849" y="1291944"/>
                <a:chExt cx="1256187" cy="1120750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3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flipH="1">
                  <a:off x="-351849" y="1291944"/>
                  <a:ext cx="1256187" cy="1120750"/>
                </a:xfrm>
                <a:prstGeom prst="rect">
                  <a:avLst/>
                </a:prstGeom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177318" y="1833497"/>
                  <a:ext cx="103471" cy="4388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u="sng" dirty="0" smtClean="0"/>
                    <a:t>#</a:t>
                  </a:r>
                  <a:endParaRPr lang="de-DE" u="sng" dirty="0"/>
                </a:p>
              </p:txBody>
            </p:sp>
          </p:grpSp>
        </p:grpSp>
        <p:sp>
          <p:nvSpPr>
            <p:cNvPr id="100" name="TextBox 99"/>
            <p:cNvSpPr txBox="1"/>
            <p:nvPr/>
          </p:nvSpPr>
          <p:spPr>
            <a:xfrm>
              <a:off x="3948599" y="443544"/>
              <a:ext cx="21793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LC-MS </a:t>
              </a:r>
              <a:r>
                <a:rPr lang="de-DE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nalytics</a:t>
              </a:r>
              <a:endPara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586" b="35286"/>
            <a:stretch/>
          </p:blipFill>
          <p:spPr>
            <a:xfrm>
              <a:off x="3571546" y="892007"/>
              <a:ext cx="2922846" cy="803450"/>
            </a:xfrm>
            <a:prstGeom prst="rect">
              <a:avLst/>
            </a:prstGeom>
          </p:spPr>
        </p:pic>
        <p:sp>
          <p:nvSpPr>
            <p:cNvPr id="101" name="TextBox 100"/>
            <p:cNvSpPr txBox="1"/>
            <p:nvPr/>
          </p:nvSpPr>
          <p:spPr>
            <a:xfrm>
              <a:off x="3964681" y="1637252"/>
              <a:ext cx="21365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lanning</a:t>
              </a:r>
              <a:r>
                <a:rPr lang="de-DE" sz="11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1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hase</a:t>
              </a:r>
              <a:endParaRPr lang="de-DE" sz="11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94" name="Picture 93"/>
            <p:cNvPicPr>
              <a:picLocks noChangeAspect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2825" y="2047416"/>
              <a:ext cx="1470926" cy="1237840"/>
            </a:xfrm>
            <a:prstGeom prst="rect">
              <a:avLst/>
            </a:prstGeom>
          </p:spPr>
        </p:pic>
        <p:sp>
          <p:nvSpPr>
            <p:cNvPr id="111" name="TextBox 110"/>
            <p:cNvSpPr txBox="1"/>
            <p:nvPr/>
          </p:nvSpPr>
          <p:spPr>
            <a:xfrm rot="16200000">
              <a:off x="9966136" y="2889075"/>
              <a:ext cx="337420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Quality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management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nd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ssurance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is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mandatory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in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very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tage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of</a:t>
              </a:r>
              <a:r>
                <a:rPr lang="de-DE" sz="1200" dirty="0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a </a:t>
              </a:r>
              <a:r>
                <a:rPr lang="de-DE" sz="1200" dirty="0" err="1" smtClean="0">
                  <a:solidFill>
                    <a:schemeClr val="bg2">
                      <a:lumMod val="25000"/>
                    </a:schemeClr>
                  </a:solidFill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tudy</a:t>
              </a:r>
              <a:endParaRPr lang="de-DE" sz="1200" dirty="0">
                <a:solidFill>
                  <a:schemeClr val="bg2">
                    <a:lumMod val="25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9093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35486" y="4992353"/>
            <a:ext cx="3099530" cy="1617989"/>
            <a:chOff x="289105" y="2353220"/>
            <a:chExt cx="3348845" cy="2041202"/>
          </a:xfrm>
        </p:grpSpPr>
        <p:sp>
          <p:nvSpPr>
            <p:cNvPr id="77" name="TextBox 76"/>
            <p:cNvSpPr txBox="1"/>
            <p:nvPr/>
          </p:nvSpPr>
          <p:spPr>
            <a:xfrm>
              <a:off x="1160447" y="2690759"/>
              <a:ext cx="2477503" cy="388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pidemiological</a:t>
              </a:r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data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105" y="3097874"/>
              <a:ext cx="1048879" cy="75081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981" y="2353220"/>
              <a:ext cx="1217233" cy="104817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22621" y="3748091"/>
              <a:ext cx="55503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b="1" dirty="0" smtClean="0"/>
                <a:t>$</a:t>
              </a:r>
              <a:endParaRPr lang="de-DE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160447" y="3314693"/>
              <a:ext cx="19972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linical </a:t>
              </a:r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cope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160447" y="3921581"/>
              <a:ext cx="19972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Funding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cxnSp>
        <p:nvCxnSpPr>
          <p:cNvPr id="38" name="Straight Arrow Connector 37"/>
          <p:cNvCxnSpPr/>
          <p:nvPr/>
        </p:nvCxnSpPr>
        <p:spPr>
          <a:xfrm flipV="1">
            <a:off x="5313407" y="3772111"/>
            <a:ext cx="1666857" cy="159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3714257" y="5085366"/>
            <a:ext cx="199724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inic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iagno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edication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emographic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5142645" y="3380954"/>
            <a:ext cx="19972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ubject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ratification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0162863" y="1478497"/>
            <a:ext cx="199724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rial desig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hort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linding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andomization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trols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67912" y="115025"/>
            <a:ext cx="33618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udy &amp;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rial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design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-532934" y="2524949"/>
            <a:ext cx="4693927" cy="2722986"/>
            <a:chOff x="-337252" y="998915"/>
            <a:chExt cx="4693927" cy="2722986"/>
          </a:xfrm>
        </p:grpSpPr>
        <p:grpSp>
          <p:nvGrpSpPr>
            <p:cNvPr id="11" name="Group 10"/>
            <p:cNvGrpSpPr/>
            <p:nvPr/>
          </p:nvGrpSpPr>
          <p:grpSpPr>
            <a:xfrm>
              <a:off x="-88157" y="998915"/>
              <a:ext cx="3488342" cy="2233694"/>
              <a:chOff x="1732520" y="297281"/>
              <a:chExt cx="3947072" cy="2581071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2395699" y="297281"/>
                <a:ext cx="3283893" cy="2407783"/>
                <a:chOff x="682339" y="351526"/>
                <a:chExt cx="2648829" cy="1979712"/>
              </a:xfrm>
            </p:grpSpPr>
            <p:grpSp>
              <p:nvGrpSpPr>
                <p:cNvPr id="15" name="Group 14"/>
                <p:cNvGrpSpPr/>
                <p:nvPr/>
              </p:nvGrpSpPr>
              <p:grpSpPr>
                <a:xfrm>
                  <a:off x="987120" y="351526"/>
                  <a:ext cx="1840883" cy="1924816"/>
                  <a:chOff x="194084" y="550481"/>
                  <a:chExt cx="2158591" cy="2158591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94084" y="550481"/>
                    <a:ext cx="2158591" cy="2158591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206703" y="1103360"/>
                    <a:ext cx="763539" cy="763539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95825" y="934815"/>
                  <a:ext cx="1380439" cy="1188712"/>
                </a:xfrm>
                <a:prstGeom prst="rect">
                  <a:avLst/>
                </a:prstGeom>
              </p:spPr>
            </p:pic>
            <p:pic>
              <p:nvPicPr>
                <p:cNvPr id="47" name="Picture 46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flipH="1">
                  <a:off x="682339" y="958249"/>
                  <a:ext cx="1429371" cy="1237504"/>
                </a:xfrm>
                <a:prstGeom prst="rect">
                  <a:avLst/>
                </a:prstGeom>
              </p:spPr>
            </p:pic>
            <p:pic>
              <p:nvPicPr>
                <p:cNvPr id="48" name="Picture 47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58032" y="1234927"/>
                  <a:ext cx="1273136" cy="1096311"/>
                </a:xfrm>
                <a:prstGeom prst="rect">
                  <a:avLst/>
                </a:prstGeom>
              </p:spPr>
            </p:pic>
          </p:grpSp>
          <p:grpSp>
            <p:nvGrpSpPr>
              <p:cNvPr id="10" name="Group 9"/>
              <p:cNvGrpSpPr/>
              <p:nvPr/>
            </p:nvGrpSpPr>
            <p:grpSpPr>
              <a:xfrm>
                <a:off x="1732520" y="1370560"/>
                <a:ext cx="1750674" cy="1507792"/>
                <a:chOff x="-243001" y="1275175"/>
                <a:chExt cx="1256187" cy="1120750"/>
              </a:xfrm>
            </p:grpSpPr>
            <p:pic>
              <p:nvPicPr>
                <p:cNvPr id="57" name="Picture 56"/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flipH="1">
                  <a:off x="-243001" y="1275175"/>
                  <a:ext cx="1256187" cy="1120750"/>
                </a:xfrm>
                <a:prstGeom prst="rect">
                  <a:avLst/>
                </a:prstGeom>
              </p:spPr>
            </p:pic>
            <p:sp>
              <p:nvSpPr>
                <p:cNvPr id="58" name="TextBox 57"/>
                <p:cNvSpPr txBox="1"/>
                <p:nvPr/>
              </p:nvSpPr>
              <p:spPr>
                <a:xfrm>
                  <a:off x="286166" y="1816728"/>
                  <a:ext cx="103471" cy="3431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2400" b="1" dirty="0" smtClean="0"/>
                    <a:t>#</a:t>
                  </a:r>
                  <a:endParaRPr lang="de-DE" sz="2400" b="1" dirty="0"/>
                </a:p>
              </p:txBody>
            </p:sp>
          </p:grpSp>
        </p:grpSp>
        <p:sp>
          <p:nvSpPr>
            <p:cNvPr id="61" name="TextBox 60"/>
            <p:cNvSpPr txBox="1"/>
            <p:nvPr/>
          </p:nvSpPr>
          <p:spPr>
            <a:xfrm>
              <a:off x="-337252" y="3145507"/>
              <a:ext cx="1997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Data </a:t>
              </a:r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cientists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85927" y="2910565"/>
              <a:ext cx="1997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takeholders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192431" y="2807659"/>
              <a:ext cx="19419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linicians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887556" y="3032745"/>
              <a:ext cx="19419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nalysts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414730" y="3321791"/>
              <a:ext cx="19419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Patient </a:t>
              </a:r>
              <a:b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</a:br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representative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pic>
        <p:nvPicPr>
          <p:cNvPr id="24" name="Picture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104" y="882884"/>
            <a:ext cx="2214776" cy="1907168"/>
          </a:xfrm>
          <a:prstGeom prst="rect">
            <a:avLst/>
          </a:prstGeom>
        </p:spPr>
      </p:pic>
      <p:grpSp>
        <p:nvGrpSpPr>
          <p:cNvPr id="46" name="Group 45"/>
          <p:cNvGrpSpPr/>
          <p:nvPr/>
        </p:nvGrpSpPr>
        <p:grpSpPr>
          <a:xfrm>
            <a:off x="624172" y="722469"/>
            <a:ext cx="1872598" cy="1326988"/>
            <a:chOff x="4593507" y="612273"/>
            <a:chExt cx="1997249" cy="1477179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58" r="24247"/>
            <a:stretch/>
          </p:blipFill>
          <p:spPr>
            <a:xfrm>
              <a:off x="5210214" y="612273"/>
              <a:ext cx="763836" cy="1252988"/>
            </a:xfrm>
            <a:prstGeom prst="rect">
              <a:avLst/>
            </a:prstGeom>
          </p:spPr>
        </p:pic>
        <p:sp>
          <p:nvSpPr>
            <p:cNvPr id="82" name="TextBox 81"/>
            <p:cNvSpPr txBox="1"/>
            <p:nvPr/>
          </p:nvSpPr>
          <p:spPr>
            <a:xfrm>
              <a:off x="4593507" y="1843231"/>
              <a:ext cx="1997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thics</a:t>
              </a:r>
              <a: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ouncil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1251310" y="1774900"/>
            <a:ext cx="1997249" cy="1155424"/>
            <a:chOff x="6500296" y="940108"/>
            <a:chExt cx="1997249" cy="1155424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3778" y="940108"/>
              <a:ext cx="1143649" cy="984809"/>
            </a:xfrm>
            <a:prstGeom prst="rect">
              <a:avLst/>
            </a:prstGeom>
          </p:spPr>
        </p:pic>
        <p:sp>
          <p:nvSpPr>
            <p:cNvPr id="83" name="TextBox 82"/>
            <p:cNvSpPr txBox="1"/>
            <p:nvPr/>
          </p:nvSpPr>
          <p:spPr>
            <a:xfrm>
              <a:off x="6500296" y="1849311"/>
              <a:ext cx="1997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Ethics</a:t>
              </a:r>
              <a:r>
                <a:rPr lang="de-DE" sz="10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0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pproval</a:t>
              </a:r>
              <a:endPara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6955265" y="1043443"/>
            <a:ext cx="3110121" cy="5127371"/>
            <a:chOff x="5383572" y="1089184"/>
            <a:chExt cx="3110121" cy="5127371"/>
          </a:xfrm>
        </p:grpSpPr>
        <p:sp>
          <p:nvSpPr>
            <p:cNvPr id="135" name="Rectangle 134"/>
            <p:cNvSpPr/>
            <p:nvPr/>
          </p:nvSpPr>
          <p:spPr>
            <a:xfrm>
              <a:off x="5568613" y="1089184"/>
              <a:ext cx="2718897" cy="512737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55" name="Group 54"/>
            <p:cNvGrpSpPr/>
            <p:nvPr/>
          </p:nvGrpSpPr>
          <p:grpSpPr>
            <a:xfrm>
              <a:off x="6727314" y="1929688"/>
              <a:ext cx="1766379" cy="1165538"/>
              <a:chOff x="6782115" y="3376619"/>
              <a:chExt cx="1766379" cy="1165538"/>
            </a:xfrm>
          </p:grpSpPr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2115" y="3376619"/>
                <a:ext cx="1115958" cy="960964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00963" y="3385388"/>
                <a:ext cx="1147531" cy="988152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63838" y="3561517"/>
                <a:ext cx="1138807" cy="980640"/>
              </a:xfrm>
              <a:prstGeom prst="rect">
                <a:avLst/>
              </a:prstGeom>
            </p:spPr>
          </p:pic>
        </p:grpSp>
        <p:grpSp>
          <p:nvGrpSpPr>
            <p:cNvPr id="54" name="Group 53"/>
            <p:cNvGrpSpPr/>
            <p:nvPr/>
          </p:nvGrpSpPr>
          <p:grpSpPr>
            <a:xfrm>
              <a:off x="6674537" y="3458073"/>
              <a:ext cx="1775905" cy="1191345"/>
              <a:chOff x="7006608" y="4432723"/>
              <a:chExt cx="1775905" cy="1191345"/>
            </a:xfrm>
          </p:grpSpPr>
          <p:pic>
            <p:nvPicPr>
              <p:cNvPr id="78" name="Picture 77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42242" y="4480078"/>
                <a:ext cx="1140271" cy="981899"/>
              </a:xfrm>
              <a:prstGeom prst="rect">
                <a:avLst/>
              </a:prstGeom>
            </p:spPr>
          </p:pic>
          <p:pic>
            <p:nvPicPr>
              <p:cNvPr id="96" name="Picture 95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06608" y="4432723"/>
                <a:ext cx="1138807" cy="980640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23580" y="4648309"/>
                <a:ext cx="1133140" cy="975759"/>
              </a:xfrm>
              <a:prstGeom prst="rect">
                <a:avLst/>
              </a:prstGeom>
            </p:spPr>
          </p:pic>
        </p:grpSp>
        <p:grpSp>
          <p:nvGrpSpPr>
            <p:cNvPr id="44" name="Group 43"/>
            <p:cNvGrpSpPr/>
            <p:nvPr/>
          </p:nvGrpSpPr>
          <p:grpSpPr>
            <a:xfrm>
              <a:off x="5547308" y="1378354"/>
              <a:ext cx="1669778" cy="1617732"/>
              <a:chOff x="5220731" y="3976503"/>
              <a:chExt cx="1669778" cy="1617732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141"/>
              <a:stretch/>
            </p:blipFill>
            <p:spPr>
              <a:xfrm>
                <a:off x="5220731" y="4445967"/>
                <a:ext cx="1669778" cy="1148268"/>
              </a:xfrm>
              <a:prstGeom prst="rect">
                <a:avLst/>
              </a:prstGeom>
            </p:spPr>
          </p:pic>
          <p:sp>
            <p:nvSpPr>
              <p:cNvPr id="104" name="TextBox 103"/>
              <p:cNvSpPr txBox="1"/>
              <p:nvPr/>
            </p:nvSpPr>
            <p:spPr>
              <a:xfrm>
                <a:off x="5814513" y="3976503"/>
                <a:ext cx="55503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3600" b="1" dirty="0"/>
                  <a:t>A</a:t>
                </a:r>
                <a:endParaRPr lang="de-DE" b="1" dirty="0"/>
              </a:p>
            </p:txBody>
          </p:sp>
        </p:grpSp>
        <p:grpSp>
          <p:nvGrpSpPr>
            <p:cNvPr id="90" name="Group 89"/>
            <p:cNvGrpSpPr/>
            <p:nvPr/>
          </p:nvGrpSpPr>
          <p:grpSpPr>
            <a:xfrm>
              <a:off x="5528724" y="2994690"/>
              <a:ext cx="1718988" cy="1544780"/>
              <a:chOff x="5516385" y="2775647"/>
              <a:chExt cx="1718988" cy="1544780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6058"/>
              <a:stretch/>
            </p:blipFill>
            <p:spPr>
              <a:xfrm>
                <a:off x="5516385" y="3373930"/>
                <a:ext cx="1718988" cy="946497"/>
              </a:xfrm>
              <a:prstGeom prst="rect">
                <a:avLst/>
              </a:prstGeom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6138884" y="2775647"/>
                <a:ext cx="55503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3600" b="1" dirty="0"/>
                  <a:t>B</a:t>
                </a:r>
                <a:endParaRPr lang="de-DE" b="1" dirty="0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5487404" y="4459044"/>
              <a:ext cx="1792336" cy="1636900"/>
              <a:chOff x="5486080" y="5139020"/>
              <a:chExt cx="1792336" cy="1636900"/>
            </a:xfrm>
          </p:grpSpPr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961"/>
              <a:stretch/>
            </p:blipFill>
            <p:spPr>
              <a:xfrm>
                <a:off x="5486080" y="5679508"/>
                <a:ext cx="1792336" cy="1096412"/>
              </a:xfrm>
              <a:prstGeom prst="rect">
                <a:avLst/>
              </a:prstGeom>
            </p:spPr>
          </p:pic>
          <p:sp>
            <p:nvSpPr>
              <p:cNvPr id="86" name="TextBox 85"/>
              <p:cNvSpPr txBox="1"/>
              <p:nvPr/>
            </p:nvSpPr>
            <p:spPr>
              <a:xfrm>
                <a:off x="6146297" y="5139020"/>
                <a:ext cx="55503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3600" b="1" dirty="0"/>
                  <a:t>C</a:t>
                </a:r>
                <a:endParaRPr lang="de-DE" b="1" dirty="0"/>
              </a:p>
            </p:txBody>
          </p:sp>
        </p:grpSp>
        <p:sp>
          <p:nvSpPr>
            <p:cNvPr id="95" name="TextBox 94"/>
            <p:cNvSpPr txBox="1"/>
            <p:nvPr/>
          </p:nvSpPr>
          <p:spPr>
            <a:xfrm>
              <a:off x="5383572" y="1190582"/>
              <a:ext cx="19972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tudy </a:t>
              </a:r>
              <a:r>
                <a:rPr lang="de-DE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ites</a:t>
              </a:r>
              <a:endPara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59" name="Group 58"/>
            <p:cNvGrpSpPr/>
            <p:nvPr/>
          </p:nvGrpSpPr>
          <p:grpSpPr>
            <a:xfrm>
              <a:off x="6700355" y="5008290"/>
              <a:ext cx="1763508" cy="1190307"/>
              <a:chOff x="6784986" y="5631461"/>
              <a:chExt cx="1763508" cy="1190307"/>
            </a:xfrm>
          </p:grpSpPr>
          <p:pic>
            <p:nvPicPr>
              <p:cNvPr id="117" name="Picture 116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15354" y="5650172"/>
                <a:ext cx="1133140" cy="975759"/>
              </a:xfrm>
              <a:prstGeom prst="rect">
                <a:avLst/>
              </a:prstGeom>
            </p:spPr>
          </p:pic>
          <p:pic>
            <p:nvPicPr>
              <p:cNvPr id="103" name="Picture 102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4986" y="5631461"/>
                <a:ext cx="1140271" cy="981899"/>
              </a:xfrm>
              <a:prstGeom prst="rect">
                <a:avLst/>
              </a:prstGeom>
            </p:spPr>
          </p:pic>
          <p:pic>
            <p:nvPicPr>
              <p:cNvPr id="108" name="Picture 107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75105" y="5833616"/>
                <a:ext cx="1147531" cy="988152"/>
              </a:xfrm>
              <a:prstGeom prst="rect">
                <a:avLst/>
              </a:prstGeom>
            </p:spPr>
          </p:pic>
        </p:grpSp>
      </p:grpSp>
      <p:grpSp>
        <p:nvGrpSpPr>
          <p:cNvPr id="2" name="Group 1"/>
          <p:cNvGrpSpPr/>
          <p:nvPr/>
        </p:nvGrpSpPr>
        <p:grpSpPr>
          <a:xfrm>
            <a:off x="3579584" y="2848777"/>
            <a:ext cx="2030377" cy="1709610"/>
            <a:chOff x="788895" y="3338176"/>
            <a:chExt cx="2030377" cy="1709610"/>
          </a:xfrm>
        </p:grpSpPr>
        <p:grpSp>
          <p:nvGrpSpPr>
            <p:cNvPr id="23" name="Group 22"/>
            <p:cNvGrpSpPr/>
            <p:nvPr/>
          </p:nvGrpSpPr>
          <p:grpSpPr>
            <a:xfrm>
              <a:off x="965585" y="3338176"/>
              <a:ext cx="1853687" cy="1503527"/>
              <a:chOff x="561459" y="3907822"/>
              <a:chExt cx="1853687" cy="1503527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561459" y="3907822"/>
                <a:ext cx="1348903" cy="1173084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6882" y="4103955"/>
                <a:ext cx="1518264" cy="1307394"/>
              </a:xfrm>
              <a:prstGeom prst="rect">
                <a:avLst/>
              </a:prstGeom>
            </p:spPr>
          </p:pic>
        </p:grpSp>
        <p:sp>
          <p:nvSpPr>
            <p:cNvPr id="124" name="TextBox 123"/>
            <p:cNvSpPr txBox="1"/>
            <p:nvPr/>
          </p:nvSpPr>
          <p:spPr>
            <a:xfrm>
              <a:off x="788895" y="4740009"/>
              <a:ext cx="19972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ubject</a:t>
              </a:r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recruitment</a:t>
              </a:r>
              <a:endPara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cxnSp>
        <p:nvCxnSpPr>
          <p:cNvPr id="127" name="Straight Arrow Connector 126"/>
          <p:cNvCxnSpPr/>
          <p:nvPr/>
        </p:nvCxnSpPr>
        <p:spPr>
          <a:xfrm flipH="1" flipV="1">
            <a:off x="1629727" y="2077722"/>
            <a:ext cx="3148" cy="793761"/>
          </a:xfrm>
          <a:prstGeom prst="straightConnector1">
            <a:avLst/>
          </a:prstGeom>
          <a:ln w="3810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Straight Arrow Connector 127"/>
          <p:cNvCxnSpPr/>
          <p:nvPr/>
        </p:nvCxnSpPr>
        <p:spPr>
          <a:xfrm>
            <a:off x="1432850" y="2137686"/>
            <a:ext cx="10741" cy="781952"/>
          </a:xfrm>
          <a:prstGeom prst="straightConnector1">
            <a:avLst/>
          </a:prstGeom>
          <a:ln w="3810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3" name="Group 132"/>
          <p:cNvGrpSpPr/>
          <p:nvPr/>
        </p:nvGrpSpPr>
        <p:grpSpPr>
          <a:xfrm>
            <a:off x="9722793" y="2693745"/>
            <a:ext cx="2278954" cy="986898"/>
            <a:chOff x="8014758" y="3812328"/>
            <a:chExt cx="2278954" cy="986898"/>
          </a:xfrm>
        </p:grpSpPr>
        <p:pic>
          <p:nvPicPr>
            <p:cNvPr id="79" name="Picture 78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14758" y="3862597"/>
              <a:ext cx="1087699" cy="936629"/>
            </a:xfrm>
            <a:prstGeom prst="rect">
              <a:avLst/>
            </a:prstGeom>
          </p:spPr>
        </p:pic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9032" y="3843899"/>
              <a:ext cx="1082752" cy="932370"/>
            </a:xfrm>
            <a:prstGeom prst="rect">
              <a:avLst/>
            </a:prstGeom>
          </p:spPr>
        </p:pic>
        <p:pic>
          <p:nvPicPr>
            <p:cNvPr id="81" name="Picture 80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74296" y="3812328"/>
              <a:ext cx="1119416" cy="963941"/>
            </a:xfrm>
            <a:prstGeom prst="rect">
              <a:avLst/>
            </a:prstGeom>
          </p:spPr>
        </p:pic>
      </p:grpSp>
      <p:grpSp>
        <p:nvGrpSpPr>
          <p:cNvPr id="42" name="Group 41"/>
          <p:cNvGrpSpPr/>
          <p:nvPr/>
        </p:nvGrpSpPr>
        <p:grpSpPr>
          <a:xfrm>
            <a:off x="10164229" y="4458862"/>
            <a:ext cx="1997249" cy="1916871"/>
            <a:chOff x="10212357" y="4567145"/>
            <a:chExt cx="1997249" cy="1916871"/>
          </a:xfrm>
        </p:grpSpPr>
        <p:pic>
          <p:nvPicPr>
            <p:cNvPr id="134" name="Picture 133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16"/>
            <a:stretch/>
          </p:blipFill>
          <p:spPr>
            <a:xfrm>
              <a:off x="10625419" y="4567145"/>
              <a:ext cx="1427755" cy="1798091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>
              <a:off x="10212357" y="6176239"/>
              <a:ext cx="19972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Sampling</a:t>
              </a:r>
            </a:p>
          </p:txBody>
        </p:sp>
      </p:grpSp>
      <p:cxnSp>
        <p:nvCxnSpPr>
          <p:cNvPr id="84" name="Straight Arrow Connector 83"/>
          <p:cNvCxnSpPr/>
          <p:nvPr/>
        </p:nvCxnSpPr>
        <p:spPr>
          <a:xfrm>
            <a:off x="3137105" y="3771588"/>
            <a:ext cx="651763" cy="101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Elbow Connector 39"/>
          <p:cNvCxnSpPr/>
          <p:nvPr/>
        </p:nvCxnSpPr>
        <p:spPr>
          <a:xfrm>
            <a:off x="10022135" y="3777276"/>
            <a:ext cx="1131139" cy="648234"/>
          </a:xfrm>
          <a:prstGeom prst="bentConnector3">
            <a:avLst>
              <a:gd name="adj1" fmla="val 99992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7" name="Picture 86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084" y="3719902"/>
            <a:ext cx="1377694" cy="1186348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962" y="4879434"/>
            <a:ext cx="1443698" cy="1489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853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8812" y="650119"/>
            <a:ext cx="1049543" cy="1098186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2157" y="786007"/>
            <a:ext cx="1406434" cy="121109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96484" y="4443436"/>
            <a:ext cx="1317093" cy="137813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7018" y="4401954"/>
            <a:ext cx="1436133" cy="1502692"/>
          </a:xfrm>
          <a:prstGeom prst="rect">
            <a:avLst/>
          </a:prstGeom>
        </p:spPr>
      </p:pic>
      <p:pic>
        <p:nvPicPr>
          <p:cNvPr id="110" name="Picture 10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0780" y="4436285"/>
            <a:ext cx="1317093" cy="1378135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9776" y="4567855"/>
            <a:ext cx="1359744" cy="1170890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112158" y="143284"/>
            <a:ext cx="59838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ing &amp; Sample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eprocessing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8811" y="888026"/>
            <a:ext cx="1409354" cy="1474671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16"/>
          <a:stretch/>
        </p:blipFill>
        <p:spPr>
          <a:xfrm>
            <a:off x="2241384" y="888026"/>
            <a:ext cx="1193542" cy="1503127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091309" y="2077930"/>
            <a:ext cx="218646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atrix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eprocessing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entrifugation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Weighing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  <a:endParaRPr lang="de-DE" sz="11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473" y="917566"/>
            <a:ext cx="931205" cy="974363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3199066" y="1955787"/>
            <a:ext cx="1681294" cy="317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2816" y="1290245"/>
            <a:ext cx="601684" cy="6016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2" cstate="print"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8340" y="1280594"/>
            <a:ext cx="629039" cy="62903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4813" y="538687"/>
            <a:ext cx="1715223" cy="1715223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0126" y="1274214"/>
            <a:ext cx="2762865" cy="2379133"/>
          </a:xfrm>
          <a:prstGeom prst="rect">
            <a:avLst/>
          </a:prstGeom>
        </p:spPr>
      </p:pic>
      <p:cxnSp>
        <p:nvCxnSpPr>
          <p:cNvPr id="43" name="Straight Arrow Connector 42"/>
          <p:cNvCxnSpPr/>
          <p:nvPr/>
        </p:nvCxnSpPr>
        <p:spPr>
          <a:xfrm flipV="1">
            <a:off x="5546558" y="1955752"/>
            <a:ext cx="508920" cy="324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V="1">
            <a:off x="7802896" y="1955751"/>
            <a:ext cx="2125850" cy="324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5359753" y="3619576"/>
            <a:ext cx="2566147" cy="2475953"/>
            <a:chOff x="4673938" y="3826458"/>
            <a:chExt cx="2566147" cy="2475953"/>
          </a:xfrm>
        </p:grpSpPr>
        <p:grpSp>
          <p:nvGrpSpPr>
            <p:cNvPr id="41" name="Group 40"/>
            <p:cNvGrpSpPr/>
            <p:nvPr/>
          </p:nvGrpSpPr>
          <p:grpSpPr>
            <a:xfrm>
              <a:off x="4673938" y="3826458"/>
              <a:ext cx="2334505" cy="2475953"/>
              <a:chOff x="2022575" y="4823680"/>
              <a:chExt cx="2087284" cy="2087284"/>
            </a:xfrm>
          </p:grpSpPr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2575" y="4823680"/>
                <a:ext cx="2087284" cy="2087284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49335" y="5070289"/>
                <a:ext cx="561404" cy="561404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92297" y="5936549"/>
                <a:ext cx="514580" cy="514580"/>
              </a:xfrm>
              <a:prstGeom prst="rect">
                <a:avLst/>
              </a:prstGeom>
            </p:spPr>
          </p:pic>
          <p:cxnSp>
            <p:nvCxnSpPr>
              <p:cNvPr id="32" name="Straight Arrow Connector 31"/>
              <p:cNvCxnSpPr/>
              <p:nvPr/>
            </p:nvCxnSpPr>
            <p:spPr>
              <a:xfrm>
                <a:off x="2914650" y="5782607"/>
                <a:ext cx="220795" cy="27654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/>
              <p:cNvCxnSpPr/>
              <p:nvPr/>
            </p:nvCxnSpPr>
            <p:spPr>
              <a:xfrm flipH="1" flipV="1">
                <a:off x="2999285" y="5718887"/>
                <a:ext cx="203496" cy="26757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8488" y="4767562"/>
              <a:ext cx="1291597" cy="1291597"/>
            </a:xfrm>
            <a:prstGeom prst="rect">
              <a:avLst/>
            </a:prstGeom>
          </p:spPr>
        </p:pic>
      </p:grpSp>
      <p:sp>
        <p:nvSpPr>
          <p:cNvPr id="42" name="Bent-Up Arrow 41"/>
          <p:cNvSpPr/>
          <p:nvPr/>
        </p:nvSpPr>
        <p:spPr>
          <a:xfrm rot="5400000">
            <a:off x="3000083" y="2232069"/>
            <a:ext cx="2274690" cy="2886779"/>
          </a:xfrm>
          <a:prstGeom prst="bentUpArrow">
            <a:avLst>
              <a:gd name="adj1" fmla="val 0"/>
              <a:gd name="adj2" fmla="val 1876"/>
              <a:gd name="adj3" fmla="val 3003"/>
            </a:avLst>
          </a:prstGeom>
          <a:solidFill>
            <a:schemeClr val="bg1">
              <a:lumMod val="50000"/>
            </a:schemeClr>
          </a:solidFill>
          <a:ln w="38100">
            <a:solidFill>
              <a:schemeClr val="bg2">
                <a:lumMod val="50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13" name="Group 12"/>
          <p:cNvGrpSpPr/>
          <p:nvPr/>
        </p:nvGrpSpPr>
        <p:grpSpPr>
          <a:xfrm>
            <a:off x="3209947" y="2953984"/>
            <a:ext cx="2186009" cy="2218646"/>
            <a:chOff x="581459" y="4457299"/>
            <a:chExt cx="1832273" cy="1832273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459" y="4457299"/>
              <a:ext cx="1832273" cy="1832273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6954" y="5173178"/>
              <a:ext cx="601684" cy="601684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2" cstate="print">
              <a:biLevel thresh="5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2478" y="5163527"/>
              <a:ext cx="629039" cy="629039"/>
            </a:xfrm>
            <a:prstGeom prst="rect">
              <a:avLst/>
            </a:prstGeom>
          </p:spPr>
        </p:pic>
      </p:grpSp>
      <p:sp>
        <p:nvSpPr>
          <p:cNvPr id="50" name="TextBox 49"/>
          <p:cNvSpPr txBox="1"/>
          <p:nvPr/>
        </p:nvSpPr>
        <p:spPr>
          <a:xfrm>
            <a:off x="1329523" y="5060171"/>
            <a:ext cx="3382775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appropriate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-analytical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otocol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orniquet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lease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olonged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intermediate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oring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emperature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ime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elay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201897" y="2230336"/>
            <a:ext cx="11357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liquoting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207248" y="3653347"/>
            <a:ext cx="245116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Fin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orage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e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anagement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iobank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F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eze-thaw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ycles</a:t>
            </a:r>
            <a:endParaRPr lang="de-DE" sz="1100" dirty="0"/>
          </a:p>
        </p:txBody>
      </p:sp>
      <p:sp>
        <p:nvSpPr>
          <p:cNvPr id="40" name="TextBox 39"/>
          <p:cNvSpPr txBox="1"/>
          <p:nvPr/>
        </p:nvSpPr>
        <p:spPr>
          <a:xfrm>
            <a:off x="7673103" y="4249063"/>
            <a:ext cx="2451166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ability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ssue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sulting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from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proper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b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e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handling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Hydrolysi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nzymatic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actions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iffusion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ocesses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Hemolysis</a:t>
            </a:r>
            <a:endParaRPr lang="de-DE" sz="1100" dirty="0"/>
          </a:p>
        </p:txBody>
      </p:sp>
      <p:sp>
        <p:nvSpPr>
          <p:cNvPr id="44" name="TextBox 43"/>
          <p:cNvSpPr txBox="1"/>
          <p:nvPr/>
        </p:nvSpPr>
        <p:spPr>
          <a:xfrm>
            <a:off x="7802896" y="2140503"/>
            <a:ext cx="218646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ermediate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orage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&amp; </a:t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hipping</a:t>
            </a:r>
            <a:endParaRPr lang="de-DE" sz="11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98153" y="2486908"/>
            <a:ext cx="199724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ing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otocol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e &amp; Tim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e I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ocessing &amp;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hipping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cxnSp>
        <p:nvCxnSpPr>
          <p:cNvPr id="53" name="Straight Arrow Connector 52"/>
          <p:cNvCxnSpPr/>
          <p:nvPr/>
        </p:nvCxnSpPr>
        <p:spPr>
          <a:xfrm>
            <a:off x="1583753" y="1957374"/>
            <a:ext cx="77497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Bent-Up Arrow 53"/>
          <p:cNvSpPr/>
          <p:nvPr/>
        </p:nvSpPr>
        <p:spPr>
          <a:xfrm rot="5400000">
            <a:off x="1771727" y="1202732"/>
            <a:ext cx="2454392" cy="5163789"/>
          </a:xfrm>
          <a:prstGeom prst="bentUpArrow">
            <a:avLst>
              <a:gd name="adj1" fmla="val 0"/>
              <a:gd name="adj2" fmla="val 1909"/>
              <a:gd name="adj3" fmla="val 2947"/>
            </a:avLst>
          </a:prstGeom>
          <a:solidFill>
            <a:schemeClr val="bg1">
              <a:lumMod val="50000"/>
            </a:schemeClr>
          </a:solidFill>
          <a:ln w="38100">
            <a:solidFill>
              <a:schemeClr val="bg2">
                <a:lumMod val="50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159" y="2941281"/>
            <a:ext cx="2186009" cy="2218646"/>
          </a:xfrm>
          <a:prstGeom prst="rect">
            <a:avLst/>
          </a:prstGeom>
          <a:ln>
            <a:noFill/>
            <a:prstDash val="lgDash"/>
          </a:ln>
        </p:spPr>
      </p:pic>
      <p:grpSp>
        <p:nvGrpSpPr>
          <p:cNvPr id="23" name="Group 22"/>
          <p:cNvGrpSpPr/>
          <p:nvPr/>
        </p:nvGrpSpPr>
        <p:grpSpPr>
          <a:xfrm>
            <a:off x="29136" y="1001789"/>
            <a:ext cx="1800056" cy="1522619"/>
            <a:chOff x="29136" y="1473368"/>
            <a:chExt cx="1800056" cy="1522619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9136" y="1473368"/>
              <a:ext cx="1428880" cy="1242637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622" y="1592392"/>
              <a:ext cx="1457570" cy="1255129"/>
            </a:xfrm>
            <a:prstGeom prst="rect">
              <a:avLst/>
            </a:prstGeom>
          </p:spPr>
        </p:pic>
        <p:sp>
          <p:nvSpPr>
            <p:cNvPr id="14" name="Teardrop 13"/>
            <p:cNvSpPr/>
            <p:nvPr/>
          </p:nvSpPr>
          <p:spPr>
            <a:xfrm rot="18849512">
              <a:off x="1201604" y="2566473"/>
              <a:ext cx="442250" cy="416777"/>
            </a:xfrm>
            <a:prstGeom prst="teardrop">
              <a:avLst>
                <a:gd name="adj" fmla="val 110115"/>
              </a:avLst>
            </a:prstGeom>
            <a:solidFill>
              <a:srgbClr val="CCBBCC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57" name="Teardrop 56"/>
          <p:cNvSpPr/>
          <p:nvPr/>
        </p:nvSpPr>
        <p:spPr>
          <a:xfrm rot="18849512">
            <a:off x="1543725" y="4024489"/>
            <a:ext cx="442250" cy="416777"/>
          </a:xfrm>
          <a:prstGeom prst="teardrop">
            <a:avLst>
              <a:gd name="adj" fmla="val 110115"/>
            </a:avLst>
          </a:prstGeom>
          <a:solidFill>
            <a:srgbClr val="CCBBCC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8" name="Straight Arrow Connector 57"/>
          <p:cNvCxnSpPr/>
          <p:nvPr/>
        </p:nvCxnSpPr>
        <p:spPr>
          <a:xfrm flipH="1" flipV="1">
            <a:off x="6657498" y="2658117"/>
            <a:ext cx="15868" cy="126543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6590500" y="3020197"/>
            <a:ext cx="6679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3600" dirty="0" smtClean="0">
                <a:solidFill>
                  <a:srgbClr val="8E9AAF"/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?</a:t>
            </a:r>
            <a:endParaRPr lang="de-DE" sz="3600" dirty="0">
              <a:solidFill>
                <a:srgbClr val="8E9AAF"/>
              </a:solidFill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78701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285725" y="90814"/>
            <a:ext cx="116522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lanning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of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quantitative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d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relative quantitative LC-MS </a:t>
            </a:r>
            <a:r>
              <a:rPr lang="de-DE" sz="280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tics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48018" y="338448"/>
            <a:ext cx="4498699" cy="2675594"/>
            <a:chOff x="348018" y="2913207"/>
            <a:chExt cx="4498699" cy="2675594"/>
          </a:xfrm>
        </p:grpSpPr>
        <p:sp>
          <p:nvSpPr>
            <p:cNvPr id="187" name="Rectangle 186"/>
            <p:cNvSpPr/>
            <p:nvPr/>
          </p:nvSpPr>
          <p:spPr>
            <a:xfrm>
              <a:off x="348018" y="3197323"/>
              <a:ext cx="4458580" cy="15810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351507" y="2913207"/>
              <a:ext cx="4495210" cy="2675594"/>
              <a:chOff x="793892" y="2827062"/>
              <a:chExt cx="4495210" cy="2675594"/>
            </a:xfrm>
          </p:grpSpPr>
          <p:sp>
            <p:nvSpPr>
              <p:cNvPr id="53" name="TextBox 52"/>
              <p:cNvSpPr txBox="1"/>
              <p:nvPr/>
            </p:nvSpPr>
            <p:spPr>
              <a:xfrm>
                <a:off x="793892" y="3924334"/>
                <a:ext cx="219069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Batch Design</a:t>
                </a:r>
                <a:endPara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13191" y="2827062"/>
                <a:ext cx="2675594" cy="2675594"/>
              </a:xfrm>
              <a:prstGeom prst="rect">
                <a:avLst/>
              </a:prstGeom>
            </p:spPr>
          </p:pic>
          <p:grpSp>
            <p:nvGrpSpPr>
              <p:cNvPr id="23" name="Group 22"/>
              <p:cNvGrpSpPr/>
              <p:nvPr/>
            </p:nvGrpSpPr>
            <p:grpSpPr>
              <a:xfrm>
                <a:off x="2472665" y="3216347"/>
                <a:ext cx="1023849" cy="556754"/>
                <a:chOff x="2417941" y="3158419"/>
                <a:chExt cx="1023849" cy="556754"/>
              </a:xfrm>
            </p:grpSpPr>
            <p:pic>
              <p:nvPicPr>
                <p:cNvPr id="114" name="Picture 113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7941" y="3158419"/>
                  <a:ext cx="457975" cy="52676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2744366" y="3253508"/>
                  <a:ext cx="69742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24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N</a:t>
                  </a:r>
                  <a:r>
                    <a:rPr lang="de-DE" sz="2400" baseline="-250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1</a:t>
                  </a:r>
                  <a:endParaRPr lang="de-DE" sz="2400" dirty="0">
                    <a:latin typeface="Adobe Fan Heiti Std B" panose="020B0700000000000000" pitchFamily="34" charset="-128"/>
                    <a:ea typeface="Adobe Fan Heiti Std B" panose="020B0700000000000000" pitchFamily="34" charset="-128"/>
                  </a:endParaRPr>
                </a:p>
              </p:txBody>
            </p:sp>
          </p:grpSp>
          <p:grpSp>
            <p:nvGrpSpPr>
              <p:cNvPr id="115" name="Group 114"/>
              <p:cNvGrpSpPr/>
              <p:nvPr/>
            </p:nvGrpSpPr>
            <p:grpSpPr>
              <a:xfrm>
                <a:off x="3368959" y="3211656"/>
                <a:ext cx="1023849" cy="556754"/>
                <a:chOff x="2417941" y="3158419"/>
                <a:chExt cx="1023849" cy="556754"/>
              </a:xfrm>
            </p:grpSpPr>
            <p:pic>
              <p:nvPicPr>
                <p:cNvPr id="116" name="Picture 115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7941" y="3158419"/>
                  <a:ext cx="457975" cy="526762"/>
                </a:xfrm>
                <a:prstGeom prst="rect">
                  <a:avLst/>
                </a:prstGeom>
              </p:spPr>
            </p:pic>
            <p:sp>
              <p:nvSpPr>
                <p:cNvPr id="117" name="TextBox 116"/>
                <p:cNvSpPr txBox="1"/>
                <p:nvPr/>
              </p:nvSpPr>
              <p:spPr>
                <a:xfrm>
                  <a:off x="2744366" y="3253508"/>
                  <a:ext cx="69742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24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N</a:t>
                  </a:r>
                  <a:r>
                    <a:rPr lang="de-DE" sz="2400" baseline="-250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2</a:t>
                  </a:r>
                  <a:endParaRPr lang="de-DE" sz="2400" dirty="0">
                    <a:latin typeface="Adobe Fan Heiti Std B" panose="020B0700000000000000" pitchFamily="34" charset="-128"/>
                    <a:ea typeface="Adobe Fan Heiti Std B" panose="020B0700000000000000" pitchFamily="34" charset="-128"/>
                  </a:endParaRPr>
                </a:p>
              </p:txBody>
            </p:sp>
          </p:grpSp>
          <p:grpSp>
            <p:nvGrpSpPr>
              <p:cNvPr id="118" name="Group 117"/>
              <p:cNvGrpSpPr/>
              <p:nvPr/>
            </p:nvGrpSpPr>
            <p:grpSpPr>
              <a:xfrm>
                <a:off x="4265253" y="3206965"/>
                <a:ext cx="1023849" cy="556754"/>
                <a:chOff x="2417941" y="3158419"/>
                <a:chExt cx="1023849" cy="556754"/>
              </a:xfrm>
            </p:grpSpPr>
            <p:pic>
              <p:nvPicPr>
                <p:cNvPr id="119" name="Picture 118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7941" y="3158419"/>
                  <a:ext cx="457975" cy="526762"/>
                </a:xfrm>
                <a:prstGeom prst="rect">
                  <a:avLst/>
                </a:prstGeom>
              </p:spPr>
            </p:pic>
            <p:sp>
              <p:nvSpPr>
                <p:cNvPr id="120" name="TextBox 119"/>
                <p:cNvSpPr txBox="1"/>
                <p:nvPr/>
              </p:nvSpPr>
              <p:spPr>
                <a:xfrm>
                  <a:off x="2744366" y="3253508"/>
                  <a:ext cx="69742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24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N</a:t>
                  </a:r>
                  <a:r>
                    <a:rPr lang="de-DE" sz="2400" baseline="-25000" dirty="0" smtClean="0">
                      <a:latin typeface="Adobe Fan Heiti Std B" panose="020B0700000000000000" pitchFamily="34" charset="-128"/>
                      <a:ea typeface="Adobe Fan Heiti Std B" panose="020B0700000000000000" pitchFamily="34" charset="-128"/>
                    </a:rPr>
                    <a:t>3</a:t>
                  </a:r>
                  <a:endParaRPr lang="de-DE" sz="2400" dirty="0">
                    <a:latin typeface="Adobe Fan Heiti Std B" panose="020B0700000000000000" pitchFamily="34" charset="-128"/>
                    <a:ea typeface="Adobe Fan Heiti Std B" panose="020B0700000000000000" pitchFamily="34" charset="-128"/>
                  </a:endParaRPr>
                </a:p>
              </p:txBody>
            </p:sp>
          </p:grpSp>
        </p:grpSp>
      </p:grpSp>
      <p:grpSp>
        <p:nvGrpSpPr>
          <p:cNvPr id="8" name="Group 7"/>
          <p:cNvGrpSpPr/>
          <p:nvPr/>
        </p:nvGrpSpPr>
        <p:grpSpPr>
          <a:xfrm>
            <a:off x="4855814" y="617965"/>
            <a:ext cx="6941880" cy="1581048"/>
            <a:chOff x="4855814" y="3192724"/>
            <a:chExt cx="6941880" cy="1581048"/>
          </a:xfrm>
        </p:grpSpPr>
        <p:sp>
          <p:nvSpPr>
            <p:cNvPr id="188" name="Rectangle 187"/>
            <p:cNvSpPr/>
            <p:nvPr/>
          </p:nvSpPr>
          <p:spPr>
            <a:xfrm>
              <a:off x="4855814" y="3192724"/>
              <a:ext cx="6941879" cy="15810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855814" y="4017334"/>
              <a:ext cx="21906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Randomization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4191" y="3700900"/>
              <a:ext cx="618460" cy="618460"/>
            </a:xfrm>
            <a:prstGeom prst="rect">
              <a:avLst/>
            </a:prstGeom>
          </p:spPr>
        </p:pic>
        <p:grpSp>
          <p:nvGrpSpPr>
            <p:cNvPr id="35" name="Group 34"/>
            <p:cNvGrpSpPr/>
            <p:nvPr/>
          </p:nvGrpSpPr>
          <p:grpSpPr>
            <a:xfrm>
              <a:off x="6382918" y="4010130"/>
              <a:ext cx="2205745" cy="715270"/>
              <a:chOff x="6424592" y="3942642"/>
              <a:chExt cx="2205745" cy="715270"/>
            </a:xfrm>
          </p:grpSpPr>
          <p:pic>
            <p:nvPicPr>
              <p:cNvPr id="121" name="Picture 12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24592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3" name="Picture 12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2056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4" name="Picture 12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653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5" name="Picture 12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12500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30" name="Picture 12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8470" y="3942642"/>
                <a:ext cx="621867" cy="715270"/>
              </a:xfrm>
              <a:prstGeom prst="rect">
                <a:avLst/>
              </a:prstGeom>
            </p:spPr>
          </p:pic>
        </p:grpSp>
        <p:grpSp>
          <p:nvGrpSpPr>
            <p:cNvPr id="34" name="Group 33"/>
            <p:cNvGrpSpPr/>
            <p:nvPr/>
          </p:nvGrpSpPr>
          <p:grpSpPr>
            <a:xfrm>
              <a:off x="9464655" y="4017334"/>
              <a:ext cx="2313862" cy="715270"/>
              <a:chOff x="9350448" y="3942642"/>
              <a:chExt cx="2313862" cy="715270"/>
            </a:xfrm>
          </p:grpSpPr>
          <p:pic>
            <p:nvPicPr>
              <p:cNvPr id="126" name="Picture 12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50448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7" name="Picture 12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3447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8" name="Picture 127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196446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29" name="Picture 12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19445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31" name="Picture 13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042443" y="3942642"/>
                <a:ext cx="621867" cy="715270"/>
              </a:xfrm>
              <a:prstGeom prst="rect">
                <a:avLst/>
              </a:prstGeom>
            </p:spPr>
          </p:pic>
        </p:grpSp>
        <p:cxnSp>
          <p:nvCxnSpPr>
            <p:cNvPr id="132" name="Straight Arrow Connector 131"/>
            <p:cNvCxnSpPr>
              <a:stCxn id="130" idx="3"/>
              <a:endCxn id="126" idx="1"/>
            </p:cNvCxnSpPr>
            <p:nvPr/>
          </p:nvCxnSpPr>
          <p:spPr>
            <a:xfrm>
              <a:off x="8588663" y="4367765"/>
              <a:ext cx="875992" cy="720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3" name="Picture 13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57830" y="3375751"/>
              <a:ext cx="667225" cy="574555"/>
            </a:xfrm>
            <a:prstGeom prst="rect">
              <a:avLst/>
            </a:prstGeom>
          </p:spPr>
        </p:pic>
        <p:pic>
          <p:nvPicPr>
            <p:cNvPr id="134" name="Picture 13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78603" y="3407890"/>
              <a:ext cx="629903" cy="542416"/>
            </a:xfrm>
            <a:prstGeom prst="rect">
              <a:avLst/>
            </a:prstGeom>
          </p:spPr>
        </p:pic>
        <p:pic>
          <p:nvPicPr>
            <p:cNvPr id="136" name="Picture 13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78112" y="3416215"/>
              <a:ext cx="620235" cy="534091"/>
            </a:xfrm>
            <a:prstGeom prst="rect">
              <a:avLst/>
            </a:prstGeom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62766" y="3400929"/>
              <a:ext cx="637986" cy="549377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56506" y="3397089"/>
              <a:ext cx="642445" cy="553217"/>
            </a:xfrm>
            <a:prstGeom prst="rect">
              <a:avLst/>
            </a:prstGeom>
          </p:spPr>
        </p:pic>
        <p:sp>
          <p:nvSpPr>
            <p:cNvPr id="139" name="TextBox 138"/>
            <p:cNvSpPr txBox="1"/>
            <p:nvPr/>
          </p:nvSpPr>
          <p:spPr>
            <a:xfrm>
              <a:off x="6458147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6850995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7243843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7636691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8029539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144" name="Picture 14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58179" y="3407890"/>
              <a:ext cx="629903" cy="542416"/>
            </a:xfrm>
            <a:prstGeom prst="rect">
              <a:avLst/>
            </a:prstGeom>
          </p:spPr>
        </p:pic>
        <p:sp>
          <p:nvSpPr>
            <p:cNvPr id="145" name="TextBox 144"/>
            <p:cNvSpPr txBox="1"/>
            <p:nvPr/>
          </p:nvSpPr>
          <p:spPr>
            <a:xfrm>
              <a:off x="9530571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146" name="Picture 145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4636" y="3395037"/>
              <a:ext cx="642445" cy="553217"/>
            </a:xfrm>
            <a:prstGeom prst="rect">
              <a:avLst/>
            </a:prstGeom>
          </p:spPr>
        </p:pic>
        <p:sp>
          <p:nvSpPr>
            <p:cNvPr id="147" name="TextBox 146"/>
            <p:cNvSpPr txBox="1"/>
            <p:nvPr/>
          </p:nvSpPr>
          <p:spPr>
            <a:xfrm>
              <a:off x="9977669" y="3201163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148" name="Picture 14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59708" y="3395037"/>
              <a:ext cx="637986" cy="549377"/>
            </a:xfrm>
            <a:prstGeom prst="rect">
              <a:avLst/>
            </a:prstGeom>
          </p:spPr>
        </p:pic>
        <p:sp>
          <p:nvSpPr>
            <p:cNvPr id="149" name="TextBox 148"/>
            <p:cNvSpPr txBox="1"/>
            <p:nvPr/>
          </p:nvSpPr>
          <p:spPr>
            <a:xfrm>
              <a:off x="11233633" y="3197323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150" name="Picture 14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58744" y="3412254"/>
              <a:ext cx="620235" cy="534091"/>
            </a:xfrm>
            <a:prstGeom prst="rect">
              <a:avLst/>
            </a:prstGeom>
          </p:spPr>
        </p:pic>
        <p:sp>
          <p:nvSpPr>
            <p:cNvPr id="151" name="TextBox 150"/>
            <p:cNvSpPr txBox="1"/>
            <p:nvPr/>
          </p:nvSpPr>
          <p:spPr>
            <a:xfrm>
              <a:off x="10824475" y="3199254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152" name="Picture 15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98864" y="3375751"/>
              <a:ext cx="667225" cy="574555"/>
            </a:xfrm>
            <a:prstGeom prst="rect">
              <a:avLst/>
            </a:prstGeom>
          </p:spPr>
        </p:pic>
        <p:sp>
          <p:nvSpPr>
            <p:cNvPr id="153" name="TextBox 152"/>
            <p:cNvSpPr txBox="1"/>
            <p:nvPr/>
          </p:nvSpPr>
          <p:spPr>
            <a:xfrm>
              <a:off x="10399181" y="3203215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sp>
        <p:nvSpPr>
          <p:cNvPr id="186" name="Rectangle 185"/>
          <p:cNvSpPr/>
          <p:nvPr/>
        </p:nvSpPr>
        <p:spPr>
          <a:xfrm>
            <a:off x="351507" y="4205831"/>
            <a:ext cx="11446187" cy="254998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7" name="Straight Arrow Connector 6"/>
          <p:cNvCxnSpPr/>
          <p:nvPr/>
        </p:nvCxnSpPr>
        <p:spPr>
          <a:xfrm flipV="1">
            <a:off x="2111332" y="6592825"/>
            <a:ext cx="8896535" cy="20945"/>
          </a:xfrm>
          <a:prstGeom prst="straightConnector1">
            <a:avLst/>
          </a:prstGeom>
          <a:ln w="19050">
            <a:prstDash val="lg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380082" y="6435993"/>
            <a:ext cx="171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atch </a:t>
            </a:r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equence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89" name="Rectangle 188"/>
          <p:cNvSpPr/>
          <p:nvPr/>
        </p:nvSpPr>
        <p:spPr>
          <a:xfrm>
            <a:off x="344001" y="2280072"/>
            <a:ext cx="11434017" cy="186506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TextBox 46"/>
          <p:cNvSpPr txBox="1"/>
          <p:nvPr/>
        </p:nvSpPr>
        <p:spPr>
          <a:xfrm>
            <a:off x="389396" y="2480531"/>
            <a:ext cx="21906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ridging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9839510" y="2415725"/>
            <a:ext cx="3105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echnical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plicates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obustness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ssessment</a:t>
            </a:r>
            <a:endParaRPr lang="de-DE" sz="11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135" name="Group 134"/>
          <p:cNvGrpSpPr/>
          <p:nvPr/>
        </p:nvGrpSpPr>
        <p:grpSpPr>
          <a:xfrm>
            <a:off x="2292907" y="4114981"/>
            <a:ext cx="1856386" cy="1878750"/>
            <a:chOff x="401078" y="1504950"/>
            <a:chExt cx="2095500" cy="2095500"/>
          </a:xfrm>
        </p:grpSpPr>
        <p:pic>
          <p:nvPicPr>
            <p:cNvPr id="154" name="Picture 153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078" y="1504950"/>
              <a:ext cx="2095500" cy="2095500"/>
            </a:xfrm>
            <a:prstGeom prst="rect">
              <a:avLst/>
            </a:prstGeom>
          </p:spPr>
        </p:pic>
        <p:cxnSp>
          <p:nvCxnSpPr>
            <p:cNvPr id="161" name="Straight Connector 160"/>
            <p:cNvCxnSpPr/>
            <p:nvPr/>
          </p:nvCxnSpPr>
          <p:spPr>
            <a:xfrm flipV="1">
              <a:off x="781050" y="1695450"/>
              <a:ext cx="1343025" cy="923925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2" name="TextBox 161"/>
          <p:cNvSpPr txBox="1"/>
          <p:nvPr/>
        </p:nvSpPr>
        <p:spPr>
          <a:xfrm>
            <a:off x="3942702" y="4994456"/>
            <a:ext cx="21906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alibration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andard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llow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uantification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163" name="Group 162"/>
          <p:cNvGrpSpPr/>
          <p:nvPr/>
        </p:nvGrpSpPr>
        <p:grpSpPr>
          <a:xfrm>
            <a:off x="381931" y="4388667"/>
            <a:ext cx="527591" cy="1422670"/>
            <a:chOff x="8179426" y="2807811"/>
            <a:chExt cx="632505" cy="1813941"/>
          </a:xfrm>
        </p:grpSpPr>
        <p:pic>
          <p:nvPicPr>
            <p:cNvPr id="164" name="Picture 163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79426" y="4184539"/>
              <a:ext cx="380120" cy="437213"/>
            </a:xfrm>
            <a:prstGeom prst="rect">
              <a:avLst/>
            </a:prstGeom>
          </p:spPr>
        </p:pic>
        <p:pic>
          <p:nvPicPr>
            <p:cNvPr id="166" name="Picture 165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31811" y="4184539"/>
              <a:ext cx="380120" cy="437213"/>
            </a:xfrm>
            <a:prstGeom prst="rect">
              <a:avLst/>
            </a:prstGeom>
          </p:spPr>
        </p:pic>
        <p:sp>
          <p:nvSpPr>
            <p:cNvPr id="167" name="Rectangle 166"/>
            <p:cNvSpPr/>
            <p:nvPr/>
          </p:nvSpPr>
          <p:spPr>
            <a:xfrm>
              <a:off x="8307161" y="2807811"/>
              <a:ext cx="136832" cy="13294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8" name="Rectangle 167"/>
            <p:cNvSpPr/>
            <p:nvPr/>
          </p:nvSpPr>
          <p:spPr>
            <a:xfrm>
              <a:off x="8559546" y="2807811"/>
              <a:ext cx="136832" cy="13294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69" name="TextBox 168"/>
          <p:cNvSpPr txBox="1"/>
          <p:nvPr/>
        </p:nvSpPr>
        <p:spPr>
          <a:xfrm>
            <a:off x="878615" y="4994456"/>
            <a:ext cx="21906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lank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e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aseline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etection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180" name="Group 179"/>
          <p:cNvGrpSpPr/>
          <p:nvPr/>
        </p:nvGrpSpPr>
        <p:grpSpPr>
          <a:xfrm>
            <a:off x="5595984" y="4115431"/>
            <a:ext cx="1856386" cy="1863507"/>
            <a:chOff x="401078" y="3057525"/>
            <a:chExt cx="2095500" cy="2095500"/>
          </a:xfrm>
        </p:grpSpPr>
        <p:pic>
          <p:nvPicPr>
            <p:cNvPr id="182" name="Picture 18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078" y="3057525"/>
              <a:ext cx="2095500" cy="2095500"/>
            </a:xfrm>
            <a:prstGeom prst="rect">
              <a:avLst/>
            </a:prstGeom>
          </p:spPr>
        </p:pic>
        <p:cxnSp>
          <p:nvCxnSpPr>
            <p:cNvPr id="190" name="Straight Connector 189"/>
            <p:cNvCxnSpPr/>
            <p:nvPr/>
          </p:nvCxnSpPr>
          <p:spPr>
            <a:xfrm flipV="1">
              <a:off x="781050" y="3714750"/>
              <a:ext cx="1343025" cy="9525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1" name="TextBox 190"/>
          <p:cNvSpPr txBox="1"/>
          <p:nvPr/>
        </p:nvSpPr>
        <p:spPr>
          <a:xfrm>
            <a:off x="7233038" y="4994456"/>
            <a:ext cx="219069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uality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trol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ra-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easurement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/>
            </a:r>
            <a:b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obustness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ccuracy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ssessment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192" name="Group 191"/>
          <p:cNvGrpSpPr/>
          <p:nvPr/>
        </p:nvGrpSpPr>
        <p:grpSpPr>
          <a:xfrm>
            <a:off x="8938212" y="4959971"/>
            <a:ext cx="1031218" cy="848016"/>
            <a:chOff x="8188938" y="5226423"/>
            <a:chExt cx="1236280" cy="1081242"/>
          </a:xfrm>
        </p:grpSpPr>
        <p:pic>
          <p:nvPicPr>
            <p:cNvPr id="193" name="Picture 19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88938" y="5870571"/>
              <a:ext cx="380017" cy="437094"/>
            </a:xfrm>
            <a:prstGeom prst="rect">
              <a:avLst/>
            </a:prstGeom>
          </p:spPr>
        </p:pic>
        <p:pic>
          <p:nvPicPr>
            <p:cNvPr id="194" name="Picture 19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25605" y="5870571"/>
              <a:ext cx="380017" cy="437094"/>
            </a:xfrm>
            <a:prstGeom prst="rect">
              <a:avLst/>
            </a:prstGeom>
          </p:spPr>
        </p:pic>
        <p:pic>
          <p:nvPicPr>
            <p:cNvPr id="195" name="Picture 194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45201" y="5870571"/>
              <a:ext cx="380017" cy="437094"/>
            </a:xfrm>
            <a:prstGeom prst="rect">
              <a:avLst/>
            </a:prstGeom>
          </p:spPr>
        </p:pic>
        <p:cxnSp>
          <p:nvCxnSpPr>
            <p:cNvPr id="196" name="Straight Connector 195"/>
            <p:cNvCxnSpPr/>
            <p:nvPr/>
          </p:nvCxnSpPr>
          <p:spPr>
            <a:xfrm>
              <a:off x="8247529" y="5725459"/>
              <a:ext cx="1130567" cy="0"/>
            </a:xfrm>
            <a:prstGeom prst="line">
              <a:avLst/>
            </a:prstGeom>
            <a:ln w="28575">
              <a:solidFill>
                <a:srgbClr val="CCBBCC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Connector 196"/>
            <p:cNvCxnSpPr/>
            <p:nvPr/>
          </p:nvCxnSpPr>
          <p:spPr>
            <a:xfrm>
              <a:off x="8246647" y="5226423"/>
              <a:ext cx="1130567" cy="0"/>
            </a:xfrm>
            <a:prstGeom prst="line">
              <a:avLst/>
            </a:prstGeom>
            <a:ln w="28575">
              <a:solidFill>
                <a:srgbClr val="CCBBCC"/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8" name="Freeform 197"/>
            <p:cNvSpPr/>
            <p:nvPr/>
          </p:nvSpPr>
          <p:spPr>
            <a:xfrm>
              <a:off x="8253506" y="5438588"/>
              <a:ext cx="1147482" cy="137459"/>
            </a:xfrm>
            <a:custGeom>
              <a:avLst/>
              <a:gdLst>
                <a:gd name="connsiteX0" fmla="*/ 0 w 1147482"/>
                <a:gd name="connsiteY0" fmla="*/ 29883 h 137459"/>
                <a:gd name="connsiteX1" fmla="*/ 131482 w 1147482"/>
                <a:gd name="connsiteY1" fmla="*/ 137459 h 137459"/>
                <a:gd name="connsiteX2" fmla="*/ 537882 w 1147482"/>
                <a:gd name="connsiteY2" fmla="*/ 0 h 137459"/>
                <a:gd name="connsiteX3" fmla="*/ 980141 w 1147482"/>
                <a:gd name="connsiteY3" fmla="*/ 89647 h 137459"/>
                <a:gd name="connsiteX4" fmla="*/ 1147482 w 1147482"/>
                <a:gd name="connsiteY4" fmla="*/ 23906 h 1374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47482" h="137459">
                  <a:moveTo>
                    <a:pt x="0" y="29883"/>
                  </a:moveTo>
                  <a:lnTo>
                    <a:pt x="131482" y="137459"/>
                  </a:lnTo>
                  <a:lnTo>
                    <a:pt x="537882" y="0"/>
                  </a:lnTo>
                  <a:lnTo>
                    <a:pt x="980141" y="89647"/>
                  </a:lnTo>
                  <a:lnTo>
                    <a:pt x="1147482" y="23906"/>
                  </a:lnTo>
                </a:path>
              </a:pathLst>
            </a:custGeom>
            <a:noFill/>
            <a:ln w="28575">
              <a:solidFill>
                <a:srgbClr val="8E9AA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99" name="TextBox 198"/>
          <p:cNvSpPr txBox="1"/>
          <p:nvPr/>
        </p:nvSpPr>
        <p:spPr>
          <a:xfrm>
            <a:off x="10056102" y="4994456"/>
            <a:ext cx="2190698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tro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lasma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er-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easurement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obustness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0" name="Oval 9"/>
          <p:cNvSpPr/>
          <p:nvPr/>
        </p:nvSpPr>
        <p:spPr>
          <a:xfrm>
            <a:off x="2126573" y="6282049"/>
            <a:ext cx="222701" cy="23471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01" name="Oval 200"/>
          <p:cNvSpPr/>
          <p:nvPr/>
        </p:nvSpPr>
        <p:spPr>
          <a:xfrm>
            <a:off x="2126573" y="5951117"/>
            <a:ext cx="222701" cy="23471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18" name="Oval 217"/>
          <p:cNvSpPr/>
          <p:nvPr/>
        </p:nvSpPr>
        <p:spPr>
          <a:xfrm>
            <a:off x="2427022" y="6282049"/>
            <a:ext cx="222701" cy="23471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19" name="Oval 218"/>
          <p:cNvSpPr/>
          <p:nvPr/>
        </p:nvSpPr>
        <p:spPr>
          <a:xfrm>
            <a:off x="2427022" y="5951117"/>
            <a:ext cx="222701" cy="23471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0" name="Oval 219"/>
          <p:cNvSpPr/>
          <p:nvPr/>
        </p:nvSpPr>
        <p:spPr>
          <a:xfrm>
            <a:off x="2731820" y="6277690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1" name="Oval 220"/>
          <p:cNvSpPr/>
          <p:nvPr/>
        </p:nvSpPr>
        <p:spPr>
          <a:xfrm>
            <a:off x="2731820" y="5946758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2" name="Oval 221"/>
          <p:cNvSpPr/>
          <p:nvPr/>
        </p:nvSpPr>
        <p:spPr>
          <a:xfrm>
            <a:off x="3032269" y="6277690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3" name="Oval 222"/>
          <p:cNvSpPr/>
          <p:nvPr/>
        </p:nvSpPr>
        <p:spPr>
          <a:xfrm>
            <a:off x="3032269" y="5946758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4" name="Oval 223"/>
          <p:cNvSpPr/>
          <p:nvPr/>
        </p:nvSpPr>
        <p:spPr>
          <a:xfrm>
            <a:off x="3332724" y="628640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5" name="Oval 224"/>
          <p:cNvSpPr/>
          <p:nvPr/>
        </p:nvSpPr>
        <p:spPr>
          <a:xfrm>
            <a:off x="3332724" y="5955469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6" name="Oval 225"/>
          <p:cNvSpPr/>
          <p:nvPr/>
        </p:nvSpPr>
        <p:spPr>
          <a:xfrm>
            <a:off x="3633173" y="628640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7" name="Oval 226"/>
          <p:cNvSpPr/>
          <p:nvPr/>
        </p:nvSpPr>
        <p:spPr>
          <a:xfrm>
            <a:off x="3633173" y="5955469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29" name="Oval 228"/>
          <p:cNvSpPr/>
          <p:nvPr/>
        </p:nvSpPr>
        <p:spPr>
          <a:xfrm>
            <a:off x="3937971" y="5951110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1" name="Oval 230"/>
          <p:cNvSpPr/>
          <p:nvPr/>
        </p:nvSpPr>
        <p:spPr>
          <a:xfrm>
            <a:off x="4238420" y="5951110"/>
            <a:ext cx="222701" cy="234717"/>
          </a:xfrm>
          <a:prstGeom prst="ellipse">
            <a:avLst/>
          </a:prstGeom>
          <a:solidFill>
            <a:srgbClr val="8E9AAF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2" name="Oval 231"/>
          <p:cNvSpPr/>
          <p:nvPr/>
        </p:nvSpPr>
        <p:spPr>
          <a:xfrm>
            <a:off x="4543208" y="6277695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3" name="Oval 232"/>
          <p:cNvSpPr/>
          <p:nvPr/>
        </p:nvSpPr>
        <p:spPr>
          <a:xfrm>
            <a:off x="4543208" y="5946763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4" name="Oval 233"/>
          <p:cNvSpPr/>
          <p:nvPr/>
        </p:nvSpPr>
        <p:spPr>
          <a:xfrm>
            <a:off x="4843657" y="6277695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5" name="Oval 234"/>
          <p:cNvSpPr/>
          <p:nvPr/>
        </p:nvSpPr>
        <p:spPr>
          <a:xfrm>
            <a:off x="4843657" y="5946763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6" name="Oval 235"/>
          <p:cNvSpPr/>
          <p:nvPr/>
        </p:nvSpPr>
        <p:spPr>
          <a:xfrm>
            <a:off x="5148455" y="6273336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7" name="Oval 236"/>
          <p:cNvSpPr/>
          <p:nvPr/>
        </p:nvSpPr>
        <p:spPr>
          <a:xfrm>
            <a:off x="5148455" y="5942404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8" name="Oval 237"/>
          <p:cNvSpPr/>
          <p:nvPr/>
        </p:nvSpPr>
        <p:spPr>
          <a:xfrm>
            <a:off x="5448904" y="6273336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39" name="Oval 238"/>
          <p:cNvSpPr/>
          <p:nvPr/>
        </p:nvSpPr>
        <p:spPr>
          <a:xfrm>
            <a:off x="5448904" y="5942404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0" name="Oval 239"/>
          <p:cNvSpPr/>
          <p:nvPr/>
        </p:nvSpPr>
        <p:spPr>
          <a:xfrm>
            <a:off x="5749359" y="6282047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1" name="Oval 240"/>
          <p:cNvSpPr/>
          <p:nvPr/>
        </p:nvSpPr>
        <p:spPr>
          <a:xfrm>
            <a:off x="5749359" y="5951115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2" name="Oval 241"/>
          <p:cNvSpPr/>
          <p:nvPr/>
        </p:nvSpPr>
        <p:spPr>
          <a:xfrm>
            <a:off x="6049808" y="6282047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3" name="Oval 242"/>
          <p:cNvSpPr/>
          <p:nvPr/>
        </p:nvSpPr>
        <p:spPr>
          <a:xfrm>
            <a:off x="6049808" y="5951115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4" name="Oval 243"/>
          <p:cNvSpPr/>
          <p:nvPr/>
        </p:nvSpPr>
        <p:spPr>
          <a:xfrm>
            <a:off x="6354606" y="6277688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5" name="Oval 244"/>
          <p:cNvSpPr/>
          <p:nvPr/>
        </p:nvSpPr>
        <p:spPr>
          <a:xfrm>
            <a:off x="6354606" y="5946756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6" name="Oval 245"/>
          <p:cNvSpPr/>
          <p:nvPr/>
        </p:nvSpPr>
        <p:spPr>
          <a:xfrm>
            <a:off x="6655055" y="6277688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7" name="Oval 246"/>
          <p:cNvSpPr/>
          <p:nvPr/>
        </p:nvSpPr>
        <p:spPr>
          <a:xfrm>
            <a:off x="6655055" y="5946756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8" name="Oval 247"/>
          <p:cNvSpPr/>
          <p:nvPr/>
        </p:nvSpPr>
        <p:spPr>
          <a:xfrm>
            <a:off x="6977264" y="629075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49" name="Oval 248"/>
          <p:cNvSpPr/>
          <p:nvPr/>
        </p:nvSpPr>
        <p:spPr>
          <a:xfrm>
            <a:off x="6977264" y="5959819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0" name="Oval 249"/>
          <p:cNvSpPr/>
          <p:nvPr/>
        </p:nvSpPr>
        <p:spPr>
          <a:xfrm>
            <a:off x="7277713" y="629075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1" name="Oval 250"/>
          <p:cNvSpPr/>
          <p:nvPr/>
        </p:nvSpPr>
        <p:spPr>
          <a:xfrm>
            <a:off x="7277713" y="5959819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2" name="Oval 251"/>
          <p:cNvSpPr/>
          <p:nvPr/>
        </p:nvSpPr>
        <p:spPr>
          <a:xfrm>
            <a:off x="7582511" y="6286392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3" name="Oval 252"/>
          <p:cNvSpPr/>
          <p:nvPr/>
        </p:nvSpPr>
        <p:spPr>
          <a:xfrm>
            <a:off x="7582511" y="5955460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4" name="Oval 253"/>
          <p:cNvSpPr/>
          <p:nvPr/>
        </p:nvSpPr>
        <p:spPr>
          <a:xfrm>
            <a:off x="7882960" y="6286392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5" name="Oval 254"/>
          <p:cNvSpPr/>
          <p:nvPr/>
        </p:nvSpPr>
        <p:spPr>
          <a:xfrm>
            <a:off x="7882960" y="5955460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6" name="Oval 255"/>
          <p:cNvSpPr/>
          <p:nvPr/>
        </p:nvSpPr>
        <p:spPr>
          <a:xfrm>
            <a:off x="8183415" y="6295103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7" name="Oval 256"/>
          <p:cNvSpPr/>
          <p:nvPr/>
        </p:nvSpPr>
        <p:spPr>
          <a:xfrm>
            <a:off x="8183415" y="596417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8" name="Oval 257"/>
          <p:cNvSpPr/>
          <p:nvPr/>
        </p:nvSpPr>
        <p:spPr>
          <a:xfrm>
            <a:off x="8483864" y="6295103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59" name="Oval 258"/>
          <p:cNvSpPr/>
          <p:nvPr/>
        </p:nvSpPr>
        <p:spPr>
          <a:xfrm>
            <a:off x="8483864" y="5964171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0" name="Oval 259"/>
          <p:cNvSpPr/>
          <p:nvPr/>
        </p:nvSpPr>
        <p:spPr>
          <a:xfrm>
            <a:off x="8788662" y="6290744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2" name="Oval 261"/>
          <p:cNvSpPr/>
          <p:nvPr/>
        </p:nvSpPr>
        <p:spPr>
          <a:xfrm>
            <a:off x="9089111" y="6290744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rgbClr val="FEEAFA"/>
              </a:solidFill>
            </a:endParaRPr>
          </a:p>
        </p:txBody>
      </p:sp>
      <p:sp>
        <p:nvSpPr>
          <p:cNvPr id="264" name="Oval 263"/>
          <p:cNvSpPr/>
          <p:nvPr/>
        </p:nvSpPr>
        <p:spPr>
          <a:xfrm>
            <a:off x="9385202" y="6290739"/>
            <a:ext cx="222701" cy="234717"/>
          </a:xfrm>
          <a:prstGeom prst="ellipse">
            <a:avLst/>
          </a:prstGeom>
          <a:solidFill>
            <a:srgbClr val="CBC0D3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5" name="Oval 264"/>
          <p:cNvSpPr/>
          <p:nvPr/>
        </p:nvSpPr>
        <p:spPr>
          <a:xfrm>
            <a:off x="9385202" y="5959807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6" name="Oval 265"/>
          <p:cNvSpPr/>
          <p:nvPr/>
        </p:nvSpPr>
        <p:spPr>
          <a:xfrm>
            <a:off x="10287825" y="6300440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7" name="Oval 266"/>
          <p:cNvSpPr/>
          <p:nvPr/>
        </p:nvSpPr>
        <p:spPr>
          <a:xfrm>
            <a:off x="9685657" y="5968518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8" name="Oval 267"/>
          <p:cNvSpPr/>
          <p:nvPr/>
        </p:nvSpPr>
        <p:spPr>
          <a:xfrm>
            <a:off x="10588274" y="6300440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69" name="Oval 268"/>
          <p:cNvSpPr/>
          <p:nvPr/>
        </p:nvSpPr>
        <p:spPr>
          <a:xfrm>
            <a:off x="9986106" y="5968518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71" name="Oval 270"/>
          <p:cNvSpPr/>
          <p:nvPr/>
        </p:nvSpPr>
        <p:spPr>
          <a:xfrm>
            <a:off x="10290904" y="5964159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73" name="Oval 272"/>
          <p:cNvSpPr/>
          <p:nvPr/>
        </p:nvSpPr>
        <p:spPr>
          <a:xfrm>
            <a:off x="10591353" y="5964159"/>
            <a:ext cx="222701" cy="234717"/>
          </a:xfrm>
          <a:prstGeom prst="ellipse">
            <a:avLst/>
          </a:prstGeom>
          <a:solidFill>
            <a:srgbClr val="FEEAFA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500" b="1" dirty="0">
              <a:solidFill>
                <a:schemeClr val="tx1"/>
              </a:solidFill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8662682" y="5791611"/>
            <a:ext cx="766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3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  <a:endParaRPr lang="de-DE" sz="36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76" name="TextBox 275"/>
          <p:cNvSpPr txBox="1"/>
          <p:nvPr/>
        </p:nvSpPr>
        <p:spPr>
          <a:xfrm>
            <a:off x="9581003" y="6118344"/>
            <a:ext cx="766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3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  <a:endParaRPr lang="de-DE" sz="36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77" name="TextBox 276"/>
          <p:cNvSpPr txBox="1"/>
          <p:nvPr/>
        </p:nvSpPr>
        <p:spPr>
          <a:xfrm>
            <a:off x="1971373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B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2272971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1628345" y="4501764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</a:t>
            </a:r>
            <a:endParaRPr lang="de-DE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1" name="TextBox 280"/>
          <p:cNvSpPr txBox="1"/>
          <p:nvPr/>
        </p:nvSpPr>
        <p:spPr>
          <a:xfrm>
            <a:off x="2574139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2" name="TextBox 281"/>
          <p:cNvSpPr txBox="1"/>
          <p:nvPr/>
        </p:nvSpPr>
        <p:spPr>
          <a:xfrm>
            <a:off x="2874774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3" name="TextBox 282"/>
          <p:cNvSpPr txBox="1"/>
          <p:nvPr/>
        </p:nvSpPr>
        <p:spPr>
          <a:xfrm>
            <a:off x="3175409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4" name="TextBox 283"/>
          <p:cNvSpPr txBox="1"/>
          <p:nvPr/>
        </p:nvSpPr>
        <p:spPr>
          <a:xfrm>
            <a:off x="3476044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5" name="TextBox 284"/>
          <p:cNvSpPr txBox="1"/>
          <p:nvPr/>
        </p:nvSpPr>
        <p:spPr>
          <a:xfrm>
            <a:off x="3776679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4077314" y="59638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7" name="TextBox 286"/>
          <p:cNvSpPr txBox="1"/>
          <p:nvPr/>
        </p:nvSpPr>
        <p:spPr>
          <a:xfrm>
            <a:off x="4382226" y="59627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4687138" y="596169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89" name="TextBox 288"/>
          <p:cNvSpPr txBox="1"/>
          <p:nvPr/>
        </p:nvSpPr>
        <p:spPr>
          <a:xfrm>
            <a:off x="4992050" y="5960633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5296962" y="5959571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5592348" y="5963272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5891824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6196622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6501420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9" name="TextBox 298"/>
          <p:cNvSpPr txBox="1"/>
          <p:nvPr/>
        </p:nvSpPr>
        <p:spPr>
          <a:xfrm>
            <a:off x="6815744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0" name="TextBox 299"/>
          <p:cNvSpPr txBox="1"/>
          <p:nvPr/>
        </p:nvSpPr>
        <p:spPr>
          <a:xfrm>
            <a:off x="7120542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1" name="TextBox 300"/>
          <p:cNvSpPr txBox="1"/>
          <p:nvPr/>
        </p:nvSpPr>
        <p:spPr>
          <a:xfrm>
            <a:off x="7425340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7730138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8034936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4" name="TextBox 303"/>
          <p:cNvSpPr txBox="1"/>
          <p:nvPr/>
        </p:nvSpPr>
        <p:spPr>
          <a:xfrm>
            <a:off x="8334971" y="5984483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5" name="TextBox 304"/>
          <p:cNvSpPr txBox="1"/>
          <p:nvPr/>
        </p:nvSpPr>
        <p:spPr>
          <a:xfrm>
            <a:off x="9226761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9527830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9828899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10139494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9" name="TextBox 308"/>
          <p:cNvSpPr txBox="1"/>
          <p:nvPr/>
        </p:nvSpPr>
        <p:spPr>
          <a:xfrm>
            <a:off x="10435800" y="5974957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3812927" y="6123919"/>
            <a:ext cx="766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3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  <a:endParaRPr lang="de-DE" sz="36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1971372" y="6297273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B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2" name="TextBox 311"/>
          <p:cNvSpPr txBox="1"/>
          <p:nvPr/>
        </p:nvSpPr>
        <p:spPr>
          <a:xfrm>
            <a:off x="2271399" y="6295894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3" name="TextBox 312"/>
          <p:cNvSpPr txBox="1"/>
          <p:nvPr/>
        </p:nvSpPr>
        <p:spPr>
          <a:xfrm>
            <a:off x="2574970" y="6293438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2874000" y="629479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5" name="TextBox 314"/>
          <p:cNvSpPr txBox="1"/>
          <p:nvPr/>
        </p:nvSpPr>
        <p:spPr>
          <a:xfrm>
            <a:off x="3183227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6" name="TextBox 315"/>
          <p:cNvSpPr txBox="1"/>
          <p:nvPr/>
        </p:nvSpPr>
        <p:spPr>
          <a:xfrm>
            <a:off x="3482928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4389566" y="6285372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8" name="TextBox 317"/>
          <p:cNvSpPr txBox="1"/>
          <p:nvPr/>
        </p:nvSpPr>
        <p:spPr>
          <a:xfrm>
            <a:off x="4691230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19" name="TextBox 318"/>
          <p:cNvSpPr txBox="1"/>
          <p:nvPr/>
        </p:nvSpPr>
        <p:spPr>
          <a:xfrm>
            <a:off x="4991865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0" name="TextBox 319"/>
          <p:cNvSpPr txBox="1"/>
          <p:nvPr/>
        </p:nvSpPr>
        <p:spPr>
          <a:xfrm>
            <a:off x="5290814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1" name="TextBox 320"/>
          <p:cNvSpPr txBox="1"/>
          <p:nvPr/>
        </p:nvSpPr>
        <p:spPr>
          <a:xfrm>
            <a:off x="5600301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</a:p>
        </p:txBody>
      </p:sp>
      <p:sp>
        <p:nvSpPr>
          <p:cNvPr id="322" name="TextBox 321"/>
          <p:cNvSpPr txBox="1"/>
          <p:nvPr/>
        </p:nvSpPr>
        <p:spPr>
          <a:xfrm>
            <a:off x="5898790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</a:p>
        </p:txBody>
      </p:sp>
      <p:sp>
        <p:nvSpPr>
          <p:cNvPr id="323" name="TextBox 322"/>
          <p:cNvSpPr txBox="1"/>
          <p:nvPr/>
        </p:nvSpPr>
        <p:spPr>
          <a:xfrm>
            <a:off x="6203526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</a:p>
        </p:txBody>
      </p:sp>
      <p:sp>
        <p:nvSpPr>
          <p:cNvPr id="324" name="TextBox 323"/>
          <p:cNvSpPr txBox="1"/>
          <p:nvPr/>
        </p:nvSpPr>
        <p:spPr>
          <a:xfrm>
            <a:off x="6506766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5" name="TextBox 324"/>
          <p:cNvSpPr txBox="1"/>
          <p:nvPr/>
        </p:nvSpPr>
        <p:spPr>
          <a:xfrm>
            <a:off x="6828684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6" name="TextBox 325"/>
          <p:cNvSpPr txBox="1"/>
          <p:nvPr/>
        </p:nvSpPr>
        <p:spPr>
          <a:xfrm>
            <a:off x="7127915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7" name="TextBox 326"/>
          <p:cNvSpPr txBox="1"/>
          <p:nvPr/>
        </p:nvSpPr>
        <p:spPr>
          <a:xfrm>
            <a:off x="7431909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7726116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9" name="TextBox 328"/>
          <p:cNvSpPr txBox="1"/>
          <p:nvPr/>
        </p:nvSpPr>
        <p:spPr>
          <a:xfrm>
            <a:off x="8030371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0" name="TextBox 329"/>
          <p:cNvSpPr txBox="1"/>
          <p:nvPr/>
        </p:nvSpPr>
        <p:spPr>
          <a:xfrm>
            <a:off x="8330273" y="6319138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1" name="TextBox 330"/>
          <p:cNvSpPr txBox="1"/>
          <p:nvPr/>
        </p:nvSpPr>
        <p:spPr>
          <a:xfrm>
            <a:off x="8638359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2" name="TextBox 331"/>
          <p:cNvSpPr txBox="1"/>
          <p:nvPr/>
        </p:nvSpPr>
        <p:spPr>
          <a:xfrm>
            <a:off x="8933911" y="6304792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9236821" y="6304325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4" name="TextBox 333"/>
          <p:cNvSpPr txBox="1"/>
          <p:nvPr/>
        </p:nvSpPr>
        <p:spPr>
          <a:xfrm>
            <a:off x="10134048" y="6313519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5" name="TextBox 334"/>
          <p:cNvSpPr txBox="1"/>
          <p:nvPr/>
        </p:nvSpPr>
        <p:spPr>
          <a:xfrm>
            <a:off x="10432990" y="6314173"/>
            <a:ext cx="533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sz="9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6" name="TextBox 335"/>
          <p:cNvSpPr txBox="1"/>
          <p:nvPr/>
        </p:nvSpPr>
        <p:spPr>
          <a:xfrm>
            <a:off x="455107" y="6209378"/>
            <a:ext cx="1719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lative quantitative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7" name="TextBox 336"/>
          <p:cNvSpPr txBox="1"/>
          <p:nvPr/>
        </p:nvSpPr>
        <p:spPr>
          <a:xfrm>
            <a:off x="999505" y="6008100"/>
            <a:ext cx="1178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uantitative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43" name="Oval 342"/>
          <p:cNvSpPr/>
          <p:nvPr/>
        </p:nvSpPr>
        <p:spPr>
          <a:xfrm>
            <a:off x="4696017" y="4415316"/>
            <a:ext cx="473372" cy="471241"/>
          </a:xfrm>
          <a:prstGeom prst="ellipse">
            <a:avLst/>
          </a:prstGeom>
          <a:solidFill>
            <a:srgbClr val="8E9AAF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8" name="TextBox 337"/>
          <p:cNvSpPr txBox="1"/>
          <p:nvPr/>
        </p:nvSpPr>
        <p:spPr>
          <a:xfrm>
            <a:off x="1056179" y="4501764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B</a:t>
            </a:r>
            <a:endParaRPr lang="de-DE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4668289" y="4501764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S</a:t>
            </a:r>
            <a:endParaRPr lang="de-DE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44" name="Oval 343"/>
          <p:cNvSpPr/>
          <p:nvPr/>
        </p:nvSpPr>
        <p:spPr>
          <a:xfrm>
            <a:off x="7753542" y="4415316"/>
            <a:ext cx="473372" cy="471241"/>
          </a:xfrm>
          <a:prstGeom prst="ellipse">
            <a:avLst/>
          </a:prstGeom>
          <a:solidFill>
            <a:srgbClr val="FEEAFA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0" name="TextBox 339"/>
          <p:cNvSpPr txBox="1"/>
          <p:nvPr/>
        </p:nvSpPr>
        <p:spPr>
          <a:xfrm>
            <a:off x="7715446" y="4501764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  <a:endParaRPr lang="de-DE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45" name="Oval 344"/>
          <p:cNvSpPr/>
          <p:nvPr/>
        </p:nvSpPr>
        <p:spPr>
          <a:xfrm>
            <a:off x="10582467" y="4415316"/>
            <a:ext cx="473372" cy="471241"/>
          </a:xfrm>
          <a:prstGeom prst="ellipse">
            <a:avLst/>
          </a:prstGeom>
          <a:solidFill>
            <a:srgbClr val="FEEAFA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1" name="TextBox 340"/>
          <p:cNvSpPr txBox="1"/>
          <p:nvPr/>
        </p:nvSpPr>
        <p:spPr>
          <a:xfrm>
            <a:off x="10548462" y="4489064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</a:t>
            </a:r>
          </a:p>
        </p:txBody>
      </p:sp>
      <p:sp>
        <p:nvSpPr>
          <p:cNvPr id="11" name="Oval 10"/>
          <p:cNvSpPr/>
          <p:nvPr/>
        </p:nvSpPr>
        <p:spPr>
          <a:xfrm>
            <a:off x="1086042" y="4415316"/>
            <a:ext cx="473372" cy="471241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2" name="Oval 341"/>
          <p:cNvSpPr/>
          <p:nvPr/>
        </p:nvSpPr>
        <p:spPr>
          <a:xfrm>
            <a:off x="1654858" y="4422535"/>
            <a:ext cx="473372" cy="471241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6" name="Oval 345"/>
          <p:cNvSpPr/>
          <p:nvPr/>
        </p:nvSpPr>
        <p:spPr>
          <a:xfrm>
            <a:off x="822721" y="782922"/>
            <a:ext cx="473372" cy="471241"/>
          </a:xfrm>
          <a:prstGeom prst="ellipse">
            <a:avLst/>
          </a:prstGeom>
          <a:solidFill>
            <a:srgbClr val="CBC0D3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7" name="TextBox 346"/>
          <p:cNvSpPr txBox="1"/>
          <p:nvPr/>
        </p:nvSpPr>
        <p:spPr>
          <a:xfrm>
            <a:off x="794993" y="869370"/>
            <a:ext cx="5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</a:t>
            </a:r>
            <a:endParaRPr lang="de-DE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22766" y="2157845"/>
            <a:ext cx="9940645" cy="2014412"/>
            <a:chOff x="1199041" y="2157845"/>
            <a:chExt cx="9940645" cy="2014412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0282" y="2157845"/>
              <a:ext cx="704576" cy="704576"/>
            </a:xfrm>
            <a:prstGeom prst="rect">
              <a:avLst/>
            </a:prstGeom>
          </p:spPr>
        </p:pic>
        <p:grpSp>
          <p:nvGrpSpPr>
            <p:cNvPr id="172" name="Group 171"/>
            <p:cNvGrpSpPr/>
            <p:nvPr/>
          </p:nvGrpSpPr>
          <p:grpSpPr>
            <a:xfrm>
              <a:off x="4814884" y="3104832"/>
              <a:ext cx="2205745" cy="715270"/>
              <a:chOff x="6424592" y="3942642"/>
              <a:chExt cx="2205745" cy="715270"/>
            </a:xfrm>
          </p:grpSpPr>
          <p:pic>
            <p:nvPicPr>
              <p:cNvPr id="173" name="Picture 17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24592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74" name="Picture 17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2056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75" name="Picture 17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653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76" name="Picture 17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12500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177" name="Picture 17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8470" y="3942642"/>
                <a:ext cx="621867" cy="715270"/>
              </a:xfrm>
              <a:prstGeom prst="rect">
                <a:avLst/>
              </a:prstGeom>
            </p:spPr>
          </p:pic>
        </p:grpSp>
        <p:pic>
          <p:nvPicPr>
            <p:cNvPr id="178" name="Picture 17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4406" y="2534637"/>
              <a:ext cx="642445" cy="553217"/>
            </a:xfrm>
            <a:prstGeom prst="rect">
              <a:avLst/>
            </a:prstGeom>
          </p:spPr>
        </p:pic>
        <p:sp>
          <p:nvSpPr>
            <p:cNvPr id="179" name="TextBox 178"/>
            <p:cNvSpPr txBox="1"/>
            <p:nvPr/>
          </p:nvSpPr>
          <p:spPr>
            <a:xfrm>
              <a:off x="5686489" y="2340763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cxnSp>
          <p:nvCxnSpPr>
            <p:cNvPr id="181" name="Straight Arrow Connector 180"/>
            <p:cNvCxnSpPr>
              <a:stCxn id="165" idx="3"/>
              <a:endCxn id="178" idx="1"/>
            </p:cNvCxnSpPr>
            <p:nvPr/>
          </p:nvCxnSpPr>
          <p:spPr>
            <a:xfrm>
              <a:off x="2633421" y="2804736"/>
              <a:ext cx="2960985" cy="651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" name="Group 1"/>
            <p:cNvGrpSpPr/>
            <p:nvPr/>
          </p:nvGrpSpPr>
          <p:grpSpPr>
            <a:xfrm>
              <a:off x="1199041" y="2334253"/>
              <a:ext cx="2230210" cy="1838004"/>
              <a:chOff x="2437291" y="2334253"/>
              <a:chExt cx="2230210" cy="1838004"/>
            </a:xfrm>
          </p:grpSpPr>
          <p:grpSp>
            <p:nvGrpSpPr>
              <p:cNvPr id="155" name="Group 154"/>
              <p:cNvGrpSpPr/>
              <p:nvPr/>
            </p:nvGrpSpPr>
            <p:grpSpPr>
              <a:xfrm>
                <a:off x="2437291" y="3122938"/>
                <a:ext cx="2205745" cy="715270"/>
                <a:chOff x="6424592" y="3942642"/>
                <a:chExt cx="2205745" cy="715270"/>
              </a:xfrm>
            </p:grpSpPr>
            <p:pic>
              <p:nvPicPr>
                <p:cNvPr id="156" name="Picture 155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424592" y="3942642"/>
                  <a:ext cx="621867" cy="715270"/>
                </a:xfrm>
                <a:prstGeom prst="rect">
                  <a:avLst/>
                </a:prstGeom>
              </p:spPr>
            </p:pic>
            <p:pic>
              <p:nvPicPr>
                <p:cNvPr id="157" name="Picture 156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820561" y="3942642"/>
                  <a:ext cx="621867" cy="715270"/>
                </a:xfrm>
                <a:prstGeom prst="rect">
                  <a:avLst/>
                </a:prstGeom>
              </p:spPr>
            </p:pic>
            <p:pic>
              <p:nvPicPr>
                <p:cNvPr id="158" name="Picture 157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16531" y="3942642"/>
                  <a:ext cx="621867" cy="715270"/>
                </a:xfrm>
                <a:prstGeom prst="rect">
                  <a:avLst/>
                </a:prstGeom>
              </p:spPr>
            </p:pic>
            <p:pic>
              <p:nvPicPr>
                <p:cNvPr id="159" name="Picture 158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612500" y="3942642"/>
                  <a:ext cx="621867" cy="715270"/>
                </a:xfrm>
                <a:prstGeom prst="rect">
                  <a:avLst/>
                </a:prstGeom>
              </p:spPr>
            </p:pic>
            <p:pic>
              <p:nvPicPr>
                <p:cNvPr id="160" name="Picture 159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008470" y="3942642"/>
                  <a:ext cx="621867" cy="715270"/>
                </a:xfrm>
                <a:prstGeom prst="rect">
                  <a:avLst/>
                </a:prstGeom>
              </p:spPr>
            </p:pic>
          </p:grpSp>
          <p:pic>
            <p:nvPicPr>
              <p:cNvPr id="165" name="Picture 164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9226" y="2528127"/>
                <a:ext cx="642445" cy="553217"/>
              </a:xfrm>
              <a:prstGeom prst="rect">
                <a:avLst/>
              </a:prstGeom>
            </p:spPr>
          </p:pic>
          <p:sp>
            <p:nvSpPr>
              <p:cNvPr id="170" name="TextBox 169"/>
              <p:cNvSpPr txBox="1"/>
              <p:nvPr/>
            </p:nvSpPr>
            <p:spPr>
              <a:xfrm>
                <a:off x="3321309" y="2334253"/>
                <a:ext cx="4628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C</a:t>
                </a:r>
                <a:endParaRPr lang="de-DE" sz="12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2476803" y="3864480"/>
                <a:ext cx="21906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Batch 1</a:t>
                </a:r>
                <a:endParaRPr lang="de-DE" sz="12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</p:grpSp>
        <p:sp>
          <p:nvSpPr>
            <p:cNvPr id="184" name="TextBox 183"/>
            <p:cNvSpPr txBox="1"/>
            <p:nvPr/>
          </p:nvSpPr>
          <p:spPr>
            <a:xfrm>
              <a:off x="4835435" y="3837363"/>
              <a:ext cx="21906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atch 2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grpSp>
          <p:nvGrpSpPr>
            <p:cNvPr id="228" name="Group 227"/>
            <p:cNvGrpSpPr/>
            <p:nvPr/>
          </p:nvGrpSpPr>
          <p:grpSpPr>
            <a:xfrm>
              <a:off x="8931907" y="3076477"/>
              <a:ext cx="2205745" cy="715270"/>
              <a:chOff x="6424592" y="3942642"/>
              <a:chExt cx="2205745" cy="715270"/>
            </a:xfrm>
          </p:grpSpPr>
          <p:pic>
            <p:nvPicPr>
              <p:cNvPr id="230" name="Picture 22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24592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261" name="Picture 26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2056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263" name="Picture 26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6531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270" name="Picture 26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12500" y="3942642"/>
                <a:ext cx="621867" cy="715270"/>
              </a:xfrm>
              <a:prstGeom prst="rect">
                <a:avLst/>
              </a:prstGeom>
            </p:spPr>
          </p:pic>
          <p:pic>
            <p:nvPicPr>
              <p:cNvPr id="272" name="Picture 271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8470" y="3942642"/>
                <a:ext cx="621867" cy="715270"/>
              </a:xfrm>
              <a:prstGeom prst="rect">
                <a:avLst/>
              </a:prstGeom>
            </p:spPr>
          </p:pic>
        </p:grpSp>
        <p:cxnSp>
          <p:nvCxnSpPr>
            <p:cNvPr id="274" name="Straight Arrow Connector 273"/>
            <p:cNvCxnSpPr/>
            <p:nvPr/>
          </p:nvCxnSpPr>
          <p:spPr>
            <a:xfrm>
              <a:off x="6896489" y="2814953"/>
              <a:ext cx="2932410" cy="651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TextBox 279"/>
            <p:cNvSpPr txBox="1"/>
            <p:nvPr/>
          </p:nvSpPr>
          <p:spPr>
            <a:xfrm>
              <a:off x="8948988" y="3799242"/>
              <a:ext cx="21906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atch 3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293" name="Picture 292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14997" y="2185195"/>
              <a:ext cx="704576" cy="704576"/>
            </a:xfrm>
            <a:prstGeom prst="rect">
              <a:avLst/>
            </a:prstGeom>
          </p:spPr>
        </p:pic>
        <p:pic>
          <p:nvPicPr>
            <p:cNvPr id="294" name="Picture 29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82643" y="2531139"/>
              <a:ext cx="637986" cy="549377"/>
            </a:xfrm>
            <a:prstGeom prst="rect">
              <a:avLst/>
            </a:prstGeom>
          </p:spPr>
        </p:pic>
        <p:sp>
          <p:nvSpPr>
            <p:cNvPr id="295" name="TextBox 294"/>
            <p:cNvSpPr txBox="1"/>
            <p:nvPr/>
          </p:nvSpPr>
          <p:spPr>
            <a:xfrm>
              <a:off x="6479721" y="2331748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296" name="Picture 29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20127" y="2481589"/>
              <a:ext cx="637986" cy="549377"/>
            </a:xfrm>
            <a:prstGeom prst="rect">
              <a:avLst/>
            </a:prstGeom>
          </p:spPr>
        </p:pic>
        <p:sp>
          <p:nvSpPr>
            <p:cNvPr id="348" name="TextBox 347"/>
            <p:cNvSpPr txBox="1"/>
            <p:nvPr/>
          </p:nvSpPr>
          <p:spPr>
            <a:xfrm>
              <a:off x="9817205" y="2282198"/>
              <a:ext cx="462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B</a:t>
              </a:r>
              <a:endParaRPr lang="de-DE" sz="12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43550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8741" y="130701"/>
            <a:ext cx="77351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ample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eparation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&amp; LC-MS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tics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4014" y="674325"/>
            <a:ext cx="5572028" cy="5763127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902179" y="1071616"/>
            <a:ext cx="12170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argeted</a:t>
            </a:r>
            <a:r>
              <a:rPr lang="de-DE" sz="1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529467" y="6233717"/>
            <a:ext cx="15235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Non-</a:t>
            </a:r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argeted</a:t>
            </a:r>
            <a:endParaRPr lang="de-DE" sz="16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algn="ctr"/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7057063" y="6134734"/>
            <a:ext cx="19503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err="1" smtClean="0">
                <a:solidFill>
                  <a:schemeClr val="tx1">
                    <a:lumMod val="50000"/>
                    <a:lumOff val="50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ntire</a:t>
            </a:r>
            <a:r>
              <a:rPr lang="de-DE" sz="1600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600" dirty="0" err="1" smtClean="0">
                <a:solidFill>
                  <a:schemeClr val="tx1">
                    <a:lumMod val="50000"/>
                    <a:lumOff val="50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ubstance</a:t>
            </a:r>
            <a:r>
              <a:rPr lang="de-DE" sz="1600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600" dirty="0" err="1" smtClean="0">
                <a:solidFill>
                  <a:schemeClr val="tx1">
                    <a:lumMod val="50000"/>
                    <a:lumOff val="50000"/>
                  </a:schemeClr>
                </a:solidFill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pace</a:t>
            </a:r>
            <a:endParaRPr lang="de-DE" sz="1400" dirty="0">
              <a:solidFill>
                <a:schemeClr val="tx1">
                  <a:lumMod val="50000"/>
                  <a:lumOff val="50000"/>
                </a:schemeClr>
              </a:solidFill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4898189" y="481031"/>
            <a:ext cx="4142477" cy="2442411"/>
            <a:chOff x="3653589" y="509606"/>
            <a:chExt cx="4142477" cy="2442411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3589" y="509606"/>
              <a:ext cx="2442411" cy="244241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91529" y="1462256"/>
              <a:ext cx="1347537" cy="1347537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75609" y="2502873"/>
              <a:ext cx="374298" cy="37429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21768" y="1782090"/>
              <a:ext cx="374298" cy="374298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0472" y="1245448"/>
              <a:ext cx="374298" cy="374298"/>
            </a:xfrm>
            <a:prstGeom prst="rect">
              <a:avLst/>
            </a:prstGeom>
          </p:spPr>
        </p:pic>
        <p:cxnSp>
          <p:nvCxnSpPr>
            <p:cNvPr id="31" name="Straight Arrow Connector 30"/>
            <p:cNvCxnSpPr/>
            <p:nvPr/>
          </p:nvCxnSpPr>
          <p:spPr>
            <a:xfrm flipV="1">
              <a:off x="6096000" y="1554646"/>
              <a:ext cx="504472" cy="335603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 flipV="1">
              <a:off x="6249513" y="1993259"/>
              <a:ext cx="1088888" cy="126334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>
              <a:off x="6290070" y="2390095"/>
              <a:ext cx="788794" cy="186188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3905061" y="2538617"/>
              <a:ext cx="19041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MS/MS</a:t>
              </a:r>
              <a:endPara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4845050" y="3342738"/>
            <a:ext cx="4679423" cy="3519000"/>
            <a:chOff x="3999553" y="3194621"/>
            <a:chExt cx="4679423" cy="351900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24"/>
            <a:stretch/>
          </p:blipFill>
          <p:spPr>
            <a:xfrm>
              <a:off x="3999553" y="4257732"/>
              <a:ext cx="2182478" cy="2251353"/>
            </a:xfrm>
            <a:prstGeom prst="rect">
              <a:avLst/>
            </a:prstGeom>
          </p:spPr>
        </p:pic>
        <p:grpSp>
          <p:nvGrpSpPr>
            <p:cNvPr id="12" name="Group 11"/>
            <p:cNvGrpSpPr/>
            <p:nvPr/>
          </p:nvGrpSpPr>
          <p:grpSpPr>
            <a:xfrm>
              <a:off x="4748463" y="3194621"/>
              <a:ext cx="3930513" cy="3519000"/>
              <a:chOff x="4748463" y="3194621"/>
              <a:chExt cx="3930513" cy="3519000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48463" y="5120117"/>
                <a:ext cx="1593504" cy="1593504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91111" y="3194621"/>
                <a:ext cx="2587865" cy="2543180"/>
              </a:xfrm>
              <a:prstGeom prst="rect">
                <a:avLst/>
              </a:prstGeom>
            </p:spPr>
          </p:pic>
          <p:cxnSp>
            <p:nvCxnSpPr>
              <p:cNvPr id="45" name="Straight Connector 44"/>
              <p:cNvCxnSpPr/>
              <p:nvPr/>
            </p:nvCxnSpPr>
            <p:spPr>
              <a:xfrm flipV="1">
                <a:off x="5946217" y="3833354"/>
                <a:ext cx="782970" cy="1417109"/>
              </a:xfrm>
              <a:prstGeom prst="line">
                <a:avLst/>
              </a:prstGeom>
              <a:ln w="3810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 flipV="1">
                <a:off x="6095610" y="5383410"/>
                <a:ext cx="1164910" cy="68489"/>
              </a:xfrm>
              <a:prstGeom prst="line">
                <a:avLst/>
              </a:prstGeom>
              <a:ln w="3810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31"/>
            <p:cNvSpPr txBox="1"/>
            <p:nvPr/>
          </p:nvSpPr>
          <p:spPr>
            <a:xfrm>
              <a:off x="4311820" y="4271549"/>
              <a:ext cx="19041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HRMS</a:t>
              </a:r>
              <a:endPara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3875" y="4140151"/>
            <a:ext cx="2536456" cy="2184171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9070134" y="768748"/>
            <a:ext cx="2967398" cy="2391871"/>
            <a:chOff x="8158830" y="659933"/>
            <a:chExt cx="3003556" cy="255311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58830" y="783119"/>
              <a:ext cx="2821849" cy="242992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13472" y="1457627"/>
              <a:ext cx="531003" cy="531003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colorTemperature colorTemp="47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33358" y="659933"/>
              <a:ext cx="572048" cy="572048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33775" y="2242684"/>
              <a:ext cx="567109" cy="567109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9861" y="800231"/>
              <a:ext cx="442525" cy="442525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79039" y="1580330"/>
              <a:ext cx="442525" cy="442525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12431" y="2434646"/>
              <a:ext cx="442525" cy="442525"/>
            </a:xfrm>
            <a:prstGeom prst="rect">
              <a:avLst/>
            </a:prstGeom>
          </p:spPr>
        </p:pic>
      </p:grpSp>
      <p:cxnSp>
        <p:nvCxnSpPr>
          <p:cNvPr id="41" name="Elbow Connector 40"/>
          <p:cNvCxnSpPr>
            <a:stCxn id="3" idx="3"/>
            <a:endCxn id="7" idx="1"/>
          </p:cNvCxnSpPr>
          <p:nvPr/>
        </p:nvCxnSpPr>
        <p:spPr>
          <a:xfrm flipV="1">
            <a:off x="3293427" y="1702237"/>
            <a:ext cx="1604762" cy="3805182"/>
          </a:xfrm>
          <a:prstGeom prst="bentConnector3">
            <a:avLst>
              <a:gd name="adj1" fmla="val 50000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Elbow Connector 48"/>
          <p:cNvCxnSpPr>
            <a:stCxn id="3" idx="3"/>
          </p:cNvCxnSpPr>
          <p:nvPr/>
        </p:nvCxnSpPr>
        <p:spPr>
          <a:xfrm>
            <a:off x="3293427" y="5507419"/>
            <a:ext cx="1579154" cy="482033"/>
          </a:xfrm>
          <a:prstGeom prst="bentConnector3">
            <a:avLst>
              <a:gd name="adj1" fmla="val 50804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6" name="Picture 7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9999" y="2611054"/>
            <a:ext cx="1381407" cy="1381407"/>
          </a:xfrm>
          <a:prstGeom prst="rect">
            <a:avLst/>
          </a:prstGeom>
        </p:spPr>
      </p:pic>
      <p:grpSp>
        <p:nvGrpSpPr>
          <p:cNvPr id="91" name="Group 90"/>
          <p:cNvGrpSpPr/>
          <p:nvPr/>
        </p:nvGrpSpPr>
        <p:grpSpPr>
          <a:xfrm>
            <a:off x="1375806" y="800305"/>
            <a:ext cx="2059958" cy="1697261"/>
            <a:chOff x="849855" y="373402"/>
            <a:chExt cx="1779272" cy="1460439"/>
          </a:xfrm>
        </p:grpSpPr>
        <p:pic>
          <p:nvPicPr>
            <p:cNvPr id="79" name="Picture 78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9855" y="373402"/>
              <a:ext cx="1598373" cy="1376376"/>
            </a:xfrm>
            <a:prstGeom prst="rect">
              <a:avLst/>
            </a:prstGeom>
          </p:spPr>
        </p:pic>
        <p:pic>
          <p:nvPicPr>
            <p:cNvPr id="77" name="Picture 76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28977" y="633691"/>
              <a:ext cx="1200150" cy="1200150"/>
            </a:xfrm>
            <a:prstGeom prst="rect">
              <a:avLst/>
            </a:prstGeom>
          </p:spPr>
        </p:pic>
      </p:grpSp>
      <p:grpSp>
        <p:nvGrpSpPr>
          <p:cNvPr id="101" name="Group 100"/>
          <p:cNvGrpSpPr/>
          <p:nvPr/>
        </p:nvGrpSpPr>
        <p:grpSpPr>
          <a:xfrm>
            <a:off x="370293" y="3905250"/>
            <a:ext cx="2923134" cy="2732365"/>
            <a:chOff x="1718441" y="2150433"/>
            <a:chExt cx="2677990" cy="2518466"/>
          </a:xfrm>
        </p:grpSpPr>
        <p:grpSp>
          <p:nvGrpSpPr>
            <p:cNvPr id="25" name="Group 24"/>
            <p:cNvGrpSpPr/>
            <p:nvPr/>
          </p:nvGrpSpPr>
          <p:grpSpPr>
            <a:xfrm>
              <a:off x="1898020" y="2150433"/>
              <a:ext cx="2498411" cy="2518466"/>
              <a:chOff x="39285" y="2568601"/>
              <a:chExt cx="2263871" cy="220016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285" y="2568601"/>
                <a:ext cx="1678245" cy="1678245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54128" y="3184188"/>
                <a:ext cx="1349028" cy="1349028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290231" y="4496150"/>
                <a:ext cx="1904166" cy="272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dirty="0" smtClean="0">
                    <a:latin typeface="Adobe Fan Heiti Std B" panose="020B0700000000000000" pitchFamily="34" charset="-128"/>
                    <a:ea typeface="Adobe Fan Heiti Std B" panose="020B0700000000000000" pitchFamily="34" charset="-128"/>
                  </a:rPr>
                  <a:t>(U)HPLC</a:t>
                </a:r>
                <a:endParaRPr lang="de-DE" sz="12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endParaRPr>
              </a:p>
            </p:txBody>
          </p:sp>
        </p:grpSp>
        <p:grpSp>
          <p:nvGrpSpPr>
            <p:cNvPr id="92" name="Group 91"/>
            <p:cNvGrpSpPr/>
            <p:nvPr/>
          </p:nvGrpSpPr>
          <p:grpSpPr>
            <a:xfrm>
              <a:off x="1718441" y="3693234"/>
              <a:ext cx="1204070" cy="565356"/>
              <a:chOff x="1405204" y="3263980"/>
              <a:chExt cx="1204070" cy="565356"/>
            </a:xfrm>
          </p:grpSpPr>
          <p:pic>
            <p:nvPicPr>
              <p:cNvPr id="87" name="Picture 86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05204" y="3263980"/>
                <a:ext cx="565356" cy="565356"/>
              </a:xfrm>
              <a:prstGeom prst="rect">
                <a:avLst/>
              </a:prstGeom>
            </p:spPr>
          </p:pic>
          <p:pic>
            <p:nvPicPr>
              <p:cNvPr id="88" name="Picture 87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24561" y="3263980"/>
                <a:ext cx="565356" cy="565356"/>
              </a:xfrm>
              <a:prstGeom prst="rect">
                <a:avLst/>
              </a:prstGeom>
            </p:spPr>
          </p:pic>
          <p:pic>
            <p:nvPicPr>
              <p:cNvPr id="89" name="Picture 88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43918" y="3263980"/>
                <a:ext cx="565356" cy="565356"/>
              </a:xfrm>
              <a:prstGeom prst="rect">
                <a:avLst/>
              </a:prstGeom>
            </p:spPr>
          </p:pic>
        </p:grpSp>
      </p:grpSp>
      <p:cxnSp>
        <p:nvCxnSpPr>
          <p:cNvPr id="96" name="Straight Arrow Connector 95"/>
          <p:cNvCxnSpPr/>
          <p:nvPr/>
        </p:nvCxnSpPr>
        <p:spPr>
          <a:xfrm flipH="1">
            <a:off x="2266953" y="2423057"/>
            <a:ext cx="2292" cy="46934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312133" y="2892402"/>
            <a:ext cx="1384875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xtraction</a:t>
            </a:r>
            <a:endParaRPr lang="de-DE" sz="16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P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L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…</a:t>
            </a:r>
            <a:endParaRPr lang="de-DE" sz="12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cxnSp>
        <p:nvCxnSpPr>
          <p:cNvPr id="105" name="Straight Arrow Connector 104"/>
          <p:cNvCxnSpPr/>
          <p:nvPr/>
        </p:nvCxnSpPr>
        <p:spPr>
          <a:xfrm flipH="1">
            <a:off x="2258777" y="3936504"/>
            <a:ext cx="2292" cy="46934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53243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270" y="132662"/>
            <a:ext cx="53891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Integration &amp; Processing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243720" y="2240043"/>
            <a:ext cx="2424444" cy="1867926"/>
            <a:chOff x="330200" y="1988458"/>
            <a:chExt cx="3589775" cy="291737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0200" y="1988458"/>
              <a:ext cx="2527235" cy="2527235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8852" y="2510973"/>
              <a:ext cx="2781123" cy="2394856"/>
            </a:xfrm>
            <a:prstGeom prst="rect">
              <a:avLst/>
            </a:prstGeom>
          </p:spPr>
        </p:pic>
      </p:grpSp>
      <p:sp>
        <p:nvSpPr>
          <p:cNvPr id="5" name="TextBox 4"/>
          <p:cNvSpPr txBox="1"/>
          <p:nvPr/>
        </p:nvSpPr>
        <p:spPr>
          <a:xfrm>
            <a:off x="174196" y="4064427"/>
            <a:ext cx="3497221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centration</a:t>
            </a:r>
            <a:r>
              <a:rPr lang="de-DE" sz="16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alculation</a:t>
            </a:r>
            <a:endParaRPr lang="de-DE" sz="16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eak </a:t>
            </a:r>
            <a:r>
              <a:rPr lang="de-DE" sz="1400" dirty="0" err="1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entification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&amp;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egration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ern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andard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ethod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valuation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(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cceptance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riteria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984" y="163123"/>
            <a:ext cx="2451372" cy="245137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7722" y="85375"/>
            <a:ext cx="2543627" cy="254362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65" y="2465429"/>
            <a:ext cx="2191091" cy="219109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0325" y="2489281"/>
            <a:ext cx="2225431" cy="222543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3088" y="4737510"/>
            <a:ext cx="2081538" cy="208153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6899" y="4680372"/>
            <a:ext cx="2251654" cy="2251654"/>
          </a:xfrm>
          <a:prstGeom prst="rect">
            <a:avLst/>
          </a:prstGeom>
        </p:spPr>
      </p:pic>
      <p:cxnSp>
        <p:nvCxnSpPr>
          <p:cNvPr id="14" name="Straight Arrow Connector 13"/>
          <p:cNvCxnSpPr/>
          <p:nvPr/>
        </p:nvCxnSpPr>
        <p:spPr>
          <a:xfrm flipV="1">
            <a:off x="6709991" y="1969382"/>
            <a:ext cx="1181339" cy="60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6626634" y="1405104"/>
            <a:ext cx="129234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issing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value</a:t>
            </a:r>
            <a:r>
              <a: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/>
            </a:r>
            <a:br>
              <a: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mputation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600985" y="3689621"/>
            <a:ext cx="13436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Normalization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677128" y="5193625"/>
            <a:ext cx="1191352" cy="954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atch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ffect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rrection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&amp;</a:t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caling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6" name="Left Brace 5"/>
          <p:cNvSpPr/>
          <p:nvPr/>
        </p:nvSpPr>
        <p:spPr>
          <a:xfrm>
            <a:off x="4346784" y="1216915"/>
            <a:ext cx="375849" cy="5435600"/>
          </a:xfrm>
          <a:prstGeom prst="leftBrace">
            <a:avLst>
              <a:gd name="adj1" fmla="val 61110"/>
              <a:gd name="adj2" fmla="val 50467"/>
            </a:avLst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5" name="Straight Arrow Connector 24"/>
          <p:cNvCxnSpPr/>
          <p:nvPr/>
        </p:nvCxnSpPr>
        <p:spPr>
          <a:xfrm flipV="1">
            <a:off x="6709991" y="4060785"/>
            <a:ext cx="1181339" cy="60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V="1">
            <a:off x="6709991" y="6221588"/>
            <a:ext cx="1181339" cy="60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Left Brace 26"/>
          <p:cNvSpPr/>
          <p:nvPr/>
        </p:nvSpPr>
        <p:spPr>
          <a:xfrm flipH="1">
            <a:off x="9926358" y="1216915"/>
            <a:ext cx="398301" cy="5435600"/>
          </a:xfrm>
          <a:prstGeom prst="leftBrace">
            <a:avLst>
              <a:gd name="adj1" fmla="val 61110"/>
              <a:gd name="adj2" fmla="val 50467"/>
            </a:avLst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Box 28"/>
          <p:cNvSpPr txBox="1"/>
          <p:nvPr/>
        </p:nvSpPr>
        <p:spPr>
          <a:xfrm>
            <a:off x="10264821" y="4434069"/>
            <a:ext cx="21896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</a:t>
            </a:r>
            <a:r>
              <a:rPr lang="de-DE" sz="16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473" y="4998689"/>
            <a:ext cx="2176470" cy="1874183"/>
          </a:xfrm>
          <a:prstGeom prst="rect">
            <a:avLst/>
          </a:prstGeom>
        </p:spPr>
      </p:pic>
      <p:grpSp>
        <p:nvGrpSpPr>
          <p:cNvPr id="31" name="Group 30"/>
          <p:cNvGrpSpPr/>
          <p:nvPr/>
        </p:nvGrpSpPr>
        <p:grpSpPr>
          <a:xfrm>
            <a:off x="1031163" y="726562"/>
            <a:ext cx="2523070" cy="1936935"/>
            <a:chOff x="8158830" y="659933"/>
            <a:chExt cx="3003556" cy="2553111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58830" y="783119"/>
              <a:ext cx="2821849" cy="2429925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13472" y="1457627"/>
              <a:ext cx="531003" cy="531003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colorTemperature colorTemp="47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33358" y="659933"/>
              <a:ext cx="572048" cy="572048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33775" y="2242684"/>
              <a:ext cx="567109" cy="567109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9861" y="800231"/>
              <a:ext cx="442525" cy="442525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79039" y="1580330"/>
              <a:ext cx="442525" cy="442525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12431" y="2434646"/>
              <a:ext cx="442525" cy="442525"/>
            </a:xfrm>
            <a:prstGeom prst="rect">
              <a:avLst/>
            </a:prstGeom>
          </p:spPr>
        </p:pic>
      </p:grpSp>
      <p:pic>
        <p:nvPicPr>
          <p:cNvPr id="15" name="Picture 1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0198" y="2469698"/>
            <a:ext cx="1066742" cy="1066742"/>
          </a:xfrm>
          <a:prstGeom prst="rect">
            <a:avLst/>
          </a:prstGeom>
        </p:spPr>
      </p:pic>
      <p:grpSp>
        <p:nvGrpSpPr>
          <p:cNvPr id="16" name="Group 15"/>
          <p:cNvGrpSpPr/>
          <p:nvPr/>
        </p:nvGrpSpPr>
        <p:grpSpPr>
          <a:xfrm>
            <a:off x="10525624" y="3162225"/>
            <a:ext cx="1668089" cy="1417979"/>
            <a:chOff x="10450982" y="3162225"/>
            <a:chExt cx="1668089" cy="1417979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50982" y="3162225"/>
              <a:ext cx="1417979" cy="1417979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23022" y="3743067"/>
              <a:ext cx="796049" cy="796049"/>
            </a:xfrm>
            <a:prstGeom prst="rect">
              <a:avLst/>
            </a:prstGeom>
          </p:spPr>
        </p:pic>
      </p:grpSp>
      <p:sp>
        <p:nvSpPr>
          <p:cNvPr id="40" name="TextBox 39"/>
          <p:cNvSpPr txBox="1"/>
          <p:nvPr/>
        </p:nvSpPr>
        <p:spPr>
          <a:xfrm>
            <a:off x="2425293" y="3316486"/>
            <a:ext cx="32221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Integration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oftware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lausibility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heck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7018944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6959" y="87232"/>
            <a:ext cx="47584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Analysis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7078" y="626990"/>
            <a:ext cx="1632166" cy="163216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5903" y="626989"/>
            <a:ext cx="1656860" cy="16568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2089" y="2566591"/>
            <a:ext cx="1711941" cy="171194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8445" y="2161788"/>
            <a:ext cx="2139929" cy="213992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8286" y="3761336"/>
            <a:ext cx="2701248" cy="270124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2678" y="151751"/>
            <a:ext cx="1830308" cy="183030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8065" y="2690369"/>
            <a:ext cx="2856711" cy="285671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4664" y="4562754"/>
            <a:ext cx="1812412" cy="1560688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539086" y="2222399"/>
            <a:ext cx="1796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assical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atistics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539086" y="4201518"/>
            <a:ext cx="1796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nsupervised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ML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539086" y="6347649"/>
            <a:ext cx="1796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upervised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ML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06219" y="4366335"/>
            <a:ext cx="16861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achine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Learning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cxnSp>
        <p:nvCxnSpPr>
          <p:cNvPr id="17" name="Elbow Connector 16"/>
          <p:cNvCxnSpPr>
            <a:stCxn id="26" idx="3"/>
          </p:cNvCxnSpPr>
          <p:nvPr/>
        </p:nvCxnSpPr>
        <p:spPr>
          <a:xfrm flipV="1">
            <a:off x="2461789" y="1483463"/>
            <a:ext cx="1899261" cy="1707316"/>
          </a:xfrm>
          <a:prstGeom prst="bentConnector3">
            <a:avLst>
              <a:gd name="adj1" fmla="val 13241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Elbow Connector 20"/>
          <p:cNvCxnSpPr>
            <a:stCxn id="15" idx="0"/>
            <a:endCxn id="6" idx="1"/>
          </p:cNvCxnSpPr>
          <p:nvPr/>
        </p:nvCxnSpPr>
        <p:spPr>
          <a:xfrm rot="5400000" flipH="1" flipV="1">
            <a:off x="3623807" y="3548054"/>
            <a:ext cx="943773" cy="692791"/>
          </a:xfrm>
          <a:prstGeom prst="bentConnector2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Elbow Connector 23"/>
          <p:cNvCxnSpPr>
            <a:stCxn id="15" idx="2"/>
          </p:cNvCxnSpPr>
          <p:nvPr/>
        </p:nvCxnSpPr>
        <p:spPr>
          <a:xfrm rot="16200000" flipH="1">
            <a:off x="3756666" y="4666744"/>
            <a:ext cx="872968" cy="887704"/>
          </a:xfrm>
          <a:prstGeom prst="bentConnector2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9299748" y="1935012"/>
            <a:ext cx="179616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athway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Biological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text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nrichment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861778" y="5519659"/>
            <a:ext cx="2234137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inic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ranslation</a:t>
            </a:r>
            <a:endParaRPr lang="de-DE" sz="14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Valid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inical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utility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valuation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of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b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udy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goals</a:t>
            </a:r>
            <a:endParaRPr lang="de-DE" sz="1200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ecision</a:t>
            </a:r>
            <a:r>
              <a:rPr lang="de-DE" sz="12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2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aking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29" name="Left Brace 28"/>
          <p:cNvSpPr/>
          <p:nvPr/>
        </p:nvSpPr>
        <p:spPr>
          <a:xfrm flipH="1">
            <a:off x="8316682" y="610452"/>
            <a:ext cx="712569" cy="5852132"/>
          </a:xfrm>
          <a:prstGeom prst="leftBrace">
            <a:avLst>
              <a:gd name="adj1" fmla="val 61110"/>
              <a:gd name="adj2" fmla="val 50467"/>
            </a:avLst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6678" y="622566"/>
            <a:ext cx="1651000" cy="16510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5906860" y="3963473"/>
            <a:ext cx="525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i="1" dirty="0" smtClean="0"/>
              <a:t>PC</a:t>
            </a:r>
            <a:r>
              <a:rPr lang="de-DE" sz="1400" i="1" baseline="-25000" dirty="0" smtClean="0"/>
              <a:t>1</a:t>
            </a:r>
            <a:endParaRPr lang="de-DE" i="1" baseline="-25000" dirty="0"/>
          </a:p>
        </p:txBody>
      </p:sp>
      <p:sp>
        <p:nvSpPr>
          <p:cNvPr id="36" name="TextBox 35"/>
          <p:cNvSpPr txBox="1"/>
          <p:nvPr/>
        </p:nvSpPr>
        <p:spPr>
          <a:xfrm>
            <a:off x="4352387" y="2458231"/>
            <a:ext cx="525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i="1" dirty="0" smtClean="0"/>
              <a:t>PC</a:t>
            </a:r>
            <a:r>
              <a:rPr lang="de-DE" sz="1400" i="1" baseline="-25000" dirty="0" smtClean="0"/>
              <a:t>2</a:t>
            </a:r>
            <a:endParaRPr lang="de-DE" i="1" baseline="-25000" dirty="0"/>
          </a:p>
        </p:txBody>
      </p:sp>
      <p:cxnSp>
        <p:nvCxnSpPr>
          <p:cNvPr id="40" name="Elbow Connector 39"/>
          <p:cNvCxnSpPr/>
          <p:nvPr/>
        </p:nvCxnSpPr>
        <p:spPr>
          <a:xfrm rot="10800000">
            <a:off x="6468448" y="5838571"/>
            <a:ext cx="877139" cy="207521"/>
          </a:xfrm>
          <a:prstGeom prst="bentConnector3">
            <a:avLst>
              <a:gd name="adj1" fmla="val 100011"/>
            </a:avLst>
          </a:prstGeom>
          <a:ln w="28575">
            <a:prstDash val="sys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7335253" y="5444411"/>
            <a:ext cx="0" cy="615344"/>
          </a:xfrm>
          <a:prstGeom prst="line">
            <a:avLst/>
          </a:prstGeom>
          <a:ln w="2857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5999136" y="6035376"/>
            <a:ext cx="17961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i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Tuning</a:t>
            </a:r>
            <a:endParaRPr lang="de-DE" sz="1100" i="1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56" name="Group 55"/>
          <p:cNvGrpSpPr/>
          <p:nvPr/>
        </p:nvGrpSpPr>
        <p:grpSpPr>
          <a:xfrm>
            <a:off x="-117996" y="1379532"/>
            <a:ext cx="2579785" cy="3915330"/>
            <a:chOff x="-68572" y="891448"/>
            <a:chExt cx="2579785" cy="3915330"/>
          </a:xfrm>
        </p:grpSpPr>
        <p:sp>
          <p:nvSpPr>
            <p:cNvPr id="55" name="Rounded Rectangle 54"/>
            <p:cNvSpPr/>
            <p:nvPr/>
          </p:nvSpPr>
          <p:spPr>
            <a:xfrm>
              <a:off x="383059" y="2618581"/>
              <a:ext cx="1451587" cy="2188197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-68572" y="891448"/>
              <a:ext cx="2579785" cy="2312499"/>
              <a:chOff x="-68572" y="891448"/>
              <a:chExt cx="2579785" cy="2312499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68572" y="891448"/>
                <a:ext cx="2270652" cy="2270652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08708" y="2201442"/>
                <a:ext cx="1002505" cy="1002505"/>
              </a:xfrm>
              <a:prstGeom prst="rect">
                <a:avLst/>
              </a:prstGeom>
            </p:spPr>
          </p:pic>
        </p:grpSp>
        <p:sp>
          <p:nvSpPr>
            <p:cNvPr id="28" name="TextBox 27"/>
            <p:cNvSpPr txBox="1"/>
            <p:nvPr/>
          </p:nvSpPr>
          <p:spPr>
            <a:xfrm>
              <a:off x="298861" y="2912754"/>
              <a:ext cx="15357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Data Analysis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164" y="3139452"/>
              <a:ext cx="1062066" cy="1062066"/>
            </a:xfrm>
            <a:prstGeom prst="rect">
              <a:avLst/>
            </a:prstGeom>
          </p:spPr>
        </p:pic>
        <p:sp>
          <p:nvSpPr>
            <p:cNvPr id="52" name="TextBox 51"/>
            <p:cNvSpPr txBox="1"/>
            <p:nvPr/>
          </p:nvSpPr>
          <p:spPr>
            <a:xfrm>
              <a:off x="301730" y="4156568"/>
              <a:ext cx="153578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Covariate</a:t>
              </a:r>
              <a:r>
                <a:rPr lang="de-DE" sz="1400" dirty="0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 </a:t>
              </a:r>
              <a:r>
                <a:rPr lang="de-DE" sz="1400" dirty="0" err="1" smtClean="0">
                  <a:latin typeface="Adobe Fan Heiti Std B" panose="020B0700000000000000" pitchFamily="34" charset="-128"/>
                  <a:ea typeface="Adobe Fan Heiti Std B" panose="020B0700000000000000" pitchFamily="34" charset="-128"/>
                </a:rPr>
                <a:t>adjustment</a:t>
              </a:r>
              <a:endParaRPr lang="de-DE" sz="1400" dirty="0">
                <a:latin typeface="Adobe Fan Heiti Std B" panose="020B0700000000000000" pitchFamily="34" charset="-128"/>
                <a:ea typeface="Adobe Fan Heiti Std B" panose="020B0700000000000000" pitchFamily="34" charset="-128"/>
              </a:endParaRPr>
            </a:p>
          </p:txBody>
        </p:sp>
      </p:grpSp>
      <p:cxnSp>
        <p:nvCxnSpPr>
          <p:cNvPr id="62" name="Elbow Connector 61"/>
          <p:cNvCxnSpPr>
            <a:stCxn id="26" idx="3"/>
            <a:endCxn id="15" idx="1"/>
          </p:cNvCxnSpPr>
          <p:nvPr/>
        </p:nvCxnSpPr>
        <p:spPr>
          <a:xfrm>
            <a:off x="2461789" y="3190779"/>
            <a:ext cx="444430" cy="1329445"/>
          </a:xfrm>
          <a:prstGeom prst="bentConnector3">
            <a:avLst>
              <a:gd name="adj1" fmla="val 56951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4016" y="5805117"/>
            <a:ext cx="1085064" cy="1085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582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Isosceles Triangle 66"/>
          <p:cNvSpPr/>
          <p:nvPr/>
        </p:nvSpPr>
        <p:spPr>
          <a:xfrm rot="5400000">
            <a:off x="4529851" y="1134724"/>
            <a:ext cx="5749874" cy="5146585"/>
          </a:xfrm>
          <a:prstGeom prst="triangle">
            <a:avLst>
              <a:gd name="adj" fmla="val 19771"/>
            </a:avLst>
          </a:prstGeom>
          <a:gradFill flip="none" rotWithShape="1">
            <a:gsLst>
              <a:gs pos="87000">
                <a:srgbClr val="DEE2FF"/>
              </a:gs>
              <a:gs pos="100000">
                <a:schemeClr val="bg1"/>
              </a:gs>
            </a:gsLst>
            <a:lin ang="54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TextBox 1"/>
          <p:cNvSpPr txBox="1"/>
          <p:nvPr/>
        </p:nvSpPr>
        <p:spPr>
          <a:xfrm>
            <a:off x="122675" y="86593"/>
            <a:ext cx="59733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uality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trol</a:t>
            </a:r>
            <a:r>
              <a:rPr lang="de-DE" sz="28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&amp; Quality </a:t>
            </a:r>
            <a:r>
              <a:rPr lang="de-DE" sz="28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ssurance</a:t>
            </a:r>
            <a:endParaRPr lang="de-DE" sz="28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388864" y="747996"/>
            <a:ext cx="1538332" cy="1409337"/>
            <a:chOff x="-144251" y="595947"/>
            <a:chExt cx="2491591" cy="225112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0775" y="595947"/>
              <a:ext cx="1886565" cy="162454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0" y="985821"/>
              <a:ext cx="1969063" cy="159026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4251" y="1408218"/>
              <a:ext cx="1438852" cy="1438852"/>
            </a:xfrm>
            <a:prstGeom prst="rect">
              <a:avLst/>
            </a:prstGeom>
          </p:spPr>
        </p:pic>
      </p:grpSp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778" y="3611651"/>
            <a:ext cx="1847419" cy="184741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48" y="5129168"/>
            <a:ext cx="1620941" cy="1620941"/>
          </a:xfrm>
          <a:prstGeom prst="rect">
            <a:avLst/>
          </a:prstGeom>
        </p:spPr>
      </p:pic>
      <p:grpSp>
        <p:nvGrpSpPr>
          <p:cNvPr id="19" name="Group 18"/>
          <p:cNvGrpSpPr/>
          <p:nvPr/>
        </p:nvGrpSpPr>
        <p:grpSpPr>
          <a:xfrm>
            <a:off x="2968360" y="779686"/>
            <a:ext cx="1760864" cy="1489289"/>
            <a:chOff x="1935667" y="2792429"/>
            <a:chExt cx="2958601" cy="2425700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5667" y="3061567"/>
              <a:ext cx="2113314" cy="2113314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8568" y="2792429"/>
              <a:ext cx="2425700" cy="2425700"/>
            </a:xfrm>
            <a:prstGeom prst="rect">
              <a:avLst/>
            </a:prstGeom>
          </p:spPr>
        </p:pic>
      </p:grpSp>
      <p:pic>
        <p:nvPicPr>
          <p:cNvPr id="13" name="Picture 1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8145" y="2157735"/>
            <a:ext cx="1751079" cy="1751079"/>
          </a:xfrm>
          <a:prstGeom prst="rect">
            <a:avLst/>
          </a:prstGeom>
        </p:spPr>
      </p:pic>
      <p:grpSp>
        <p:nvGrpSpPr>
          <p:cNvPr id="20" name="Group 19"/>
          <p:cNvGrpSpPr/>
          <p:nvPr/>
        </p:nvGrpSpPr>
        <p:grpSpPr>
          <a:xfrm>
            <a:off x="3079697" y="4006979"/>
            <a:ext cx="1229972" cy="1122189"/>
            <a:chOff x="6743351" y="2792429"/>
            <a:chExt cx="2719372" cy="2275120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37745" y="2792429"/>
              <a:ext cx="1824978" cy="182497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43351" y="3147168"/>
              <a:ext cx="1920381" cy="1920381"/>
            </a:xfrm>
            <a:prstGeom prst="rect">
              <a:avLst/>
            </a:prstGeom>
          </p:spPr>
        </p:pic>
      </p:grpSp>
      <p:grpSp>
        <p:nvGrpSpPr>
          <p:cNvPr id="21" name="Group 20"/>
          <p:cNvGrpSpPr/>
          <p:nvPr/>
        </p:nvGrpSpPr>
        <p:grpSpPr>
          <a:xfrm>
            <a:off x="3118307" y="5305075"/>
            <a:ext cx="1454006" cy="1266373"/>
            <a:chOff x="9558126" y="2792429"/>
            <a:chExt cx="2504794" cy="2130179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8126" y="2792429"/>
              <a:ext cx="1920381" cy="1920381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00820" y="3360508"/>
              <a:ext cx="1562100" cy="1562100"/>
            </a:xfrm>
            <a:prstGeom prst="rect">
              <a:avLst/>
            </a:prstGeom>
          </p:spPr>
        </p:pic>
      </p:grpSp>
      <p:cxnSp>
        <p:nvCxnSpPr>
          <p:cNvPr id="25" name="Elbow Connector 24"/>
          <p:cNvCxnSpPr>
            <a:stCxn id="13" idx="3"/>
            <a:endCxn id="14" idx="3"/>
          </p:cNvCxnSpPr>
          <p:nvPr/>
        </p:nvCxnSpPr>
        <p:spPr>
          <a:xfrm flipH="1">
            <a:off x="4309669" y="3033275"/>
            <a:ext cx="419555" cy="1423784"/>
          </a:xfrm>
          <a:prstGeom prst="bentConnector3">
            <a:avLst>
              <a:gd name="adj1" fmla="val -54486"/>
            </a:avLst>
          </a:prstGeom>
          <a:ln w="57150">
            <a:solidFill>
              <a:srgbClr val="8E9AA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endCxn id="48" idx="1"/>
          </p:cNvCxnSpPr>
          <p:nvPr/>
        </p:nvCxnSpPr>
        <p:spPr>
          <a:xfrm>
            <a:off x="4967416" y="3540211"/>
            <a:ext cx="1490289" cy="7008"/>
          </a:xfrm>
          <a:prstGeom prst="straightConnector1">
            <a:avLst/>
          </a:prstGeom>
          <a:ln w="57150">
            <a:solidFill>
              <a:srgbClr val="8E9AA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263333" y="2031462"/>
            <a:ext cx="1170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inic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968360" y="3598343"/>
            <a:ext cx="1810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e-analytical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93990" y="5082984"/>
            <a:ext cx="21366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- &amp;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Metadata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780486" y="6532325"/>
            <a:ext cx="21366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storage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93939" y="2114002"/>
            <a:ext cx="1455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linic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hase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5945" y="3587678"/>
            <a:ext cx="1979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re-analytical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hase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85945" y="5061354"/>
            <a:ext cx="1979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tical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phase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49177" y="6529560"/>
            <a:ext cx="1979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Data </a:t>
            </a: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nalysis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>
            <a:off x="2150202" y="1488734"/>
            <a:ext cx="720597" cy="9525"/>
          </a:xfrm>
          <a:prstGeom prst="straightConnector1">
            <a:avLst/>
          </a:prstGeom>
          <a:ln w="57150">
            <a:solidFill>
              <a:srgbClr val="8E9AAF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2150202" y="3018945"/>
            <a:ext cx="720597" cy="9525"/>
          </a:xfrm>
          <a:prstGeom prst="straightConnector1">
            <a:avLst/>
          </a:prstGeom>
          <a:ln w="57150">
            <a:solidFill>
              <a:srgbClr val="8E9AAF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2150202" y="4415863"/>
            <a:ext cx="720597" cy="9525"/>
          </a:xfrm>
          <a:prstGeom prst="straightConnector1">
            <a:avLst/>
          </a:prstGeom>
          <a:ln w="57150">
            <a:solidFill>
              <a:srgbClr val="8E9AAF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2150202" y="5967056"/>
            <a:ext cx="720597" cy="9525"/>
          </a:xfrm>
          <a:prstGeom prst="straightConnector1">
            <a:avLst/>
          </a:prstGeom>
          <a:ln w="57150">
            <a:solidFill>
              <a:srgbClr val="8E9AAF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6457705" y="3224053"/>
            <a:ext cx="21656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Explanatory</a:t>
            </a:r>
            <a:r>
              <a:rPr lang="de-DE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(Input) variables</a:t>
            </a:r>
            <a:endParaRPr lang="de-DE" b="1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642589" y="3273477"/>
            <a:ext cx="21656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Outcome</a:t>
            </a:r>
            <a:br>
              <a:rPr lang="de-DE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(Output) variables</a:t>
            </a:r>
            <a:endParaRPr lang="de-DE" b="1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>
            <a:off x="8493666" y="3596643"/>
            <a:ext cx="1278663" cy="0"/>
          </a:xfrm>
          <a:prstGeom prst="straightConnector1">
            <a:avLst/>
          </a:prstGeom>
          <a:ln w="57150">
            <a:solidFill>
              <a:srgbClr val="8E9AA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Elbow Connector 54"/>
          <p:cNvCxnSpPr/>
          <p:nvPr/>
        </p:nvCxnSpPr>
        <p:spPr>
          <a:xfrm flipV="1">
            <a:off x="4967416" y="3596645"/>
            <a:ext cx="3526250" cy="2387084"/>
          </a:xfrm>
          <a:prstGeom prst="bentConnector3">
            <a:avLst>
              <a:gd name="adj1" fmla="val 117281"/>
            </a:avLst>
          </a:prstGeom>
          <a:ln w="57150">
            <a:solidFill>
              <a:srgbClr val="8E9AA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Picture 6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1078" y="715793"/>
            <a:ext cx="996300" cy="996300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9502383" y="1583919"/>
            <a:ext cx="2535429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800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QC</a:t>
            </a:r>
          </a:p>
          <a:p>
            <a:pPr marL="171450" indent="-171450" algn="ctr">
              <a:buFont typeface="Arial" panose="020B0604020202020204" pitchFamily="34" charset="0"/>
              <a:buChar char="•"/>
            </a:pPr>
            <a:r>
              <a:rPr lang="de-DE" sz="1400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chieves</a:t>
            </a:r>
            <a:r>
              <a:rPr lang="de-DE" sz="1400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producibility</a:t>
            </a:r>
            <a:endParaRPr lang="de-DE" sz="1400" b="1" dirty="0" smtClean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  <a:p>
            <a:pPr marL="171450" indent="-171450" algn="ctr">
              <a:buFont typeface="Arial" panose="020B0604020202020204" pitchFamily="34" charset="0"/>
              <a:buChar char="•"/>
            </a:pPr>
            <a:r>
              <a:rPr lang="de-DE" sz="1400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Gives</a:t>
            </a:r>
            <a:r>
              <a:rPr lang="de-DE" sz="1400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r>
              <a:rPr lang="de-DE" sz="1400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onfidence</a:t>
            </a:r>
            <a:r>
              <a:rPr lang="de-DE" sz="1400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in </a:t>
            </a:r>
            <a:r>
              <a:rPr lang="de-DE" sz="1400" b="1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results</a:t>
            </a:r>
            <a:r>
              <a:rPr lang="de-DE" sz="100" b="1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 </a:t>
            </a:r>
            <a:endParaRPr lang="de-DE" sz="100" b="1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  <p:pic>
        <p:nvPicPr>
          <p:cNvPr id="70" name="Picture 6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499" y="2768945"/>
            <a:ext cx="702630" cy="702630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6462" y="2560133"/>
            <a:ext cx="731044" cy="731044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7671" y="3852069"/>
            <a:ext cx="642835" cy="642835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6583" y="2561888"/>
            <a:ext cx="760617" cy="760617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7267" y="3720776"/>
            <a:ext cx="710916" cy="710916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0423" y="2839480"/>
            <a:ext cx="753275" cy="753275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9589" y="3854080"/>
            <a:ext cx="1631693" cy="1631693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829" y="2404287"/>
            <a:ext cx="1237892" cy="1237892"/>
          </a:xfrm>
          <a:prstGeom prst="rect">
            <a:avLst/>
          </a:prstGeom>
        </p:spPr>
      </p:pic>
      <p:cxnSp>
        <p:nvCxnSpPr>
          <p:cNvPr id="51" name="Elbow Connector 50"/>
          <p:cNvCxnSpPr>
            <a:stCxn id="12" idx="3"/>
            <a:endCxn id="14" idx="3"/>
          </p:cNvCxnSpPr>
          <p:nvPr/>
        </p:nvCxnSpPr>
        <p:spPr>
          <a:xfrm flipH="1">
            <a:off x="4309669" y="1524331"/>
            <a:ext cx="419555" cy="2932728"/>
          </a:xfrm>
          <a:prstGeom prst="bentConnector3">
            <a:avLst>
              <a:gd name="adj1" fmla="val -54486"/>
            </a:avLst>
          </a:prstGeom>
          <a:ln w="57150">
            <a:solidFill>
              <a:srgbClr val="8E9AA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1512" y="3646765"/>
            <a:ext cx="431732" cy="431732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4599072" y="4049775"/>
            <a:ext cx="21366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Acceptance</a:t>
            </a:r>
            <a: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/>
            </a:r>
            <a:br>
              <a:rPr lang="de-DE" sz="1400" dirty="0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</a:br>
            <a:r>
              <a:rPr lang="de-DE" sz="1400" dirty="0" err="1" smtClean="0">
                <a:latin typeface="Adobe Fan Heiti Std B" panose="020B0700000000000000" pitchFamily="34" charset="-128"/>
                <a:ea typeface="Adobe Fan Heiti Std B" panose="020B0700000000000000" pitchFamily="34" charset="-128"/>
              </a:rPr>
              <a:t>criteria</a:t>
            </a:r>
            <a:endParaRPr lang="de-DE" sz="1400" dirty="0">
              <a:latin typeface="Adobe Fan Heiti Std B" panose="020B0700000000000000" pitchFamily="34" charset="-128"/>
              <a:ea typeface="Adobe Fan Heiti Std B" panose="020B07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034392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1</Words>
  <Application>Microsoft Office PowerPoint</Application>
  <PresentationFormat>Widescreen</PresentationFormat>
  <Paragraphs>238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dobe Fan Heiti Std B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uel Rischke</dc:creator>
  <cp:lastModifiedBy>Samuel Rischke</cp:lastModifiedBy>
  <cp:revision>141</cp:revision>
  <dcterms:created xsi:type="dcterms:W3CDTF">2022-06-15T09:10:15Z</dcterms:created>
  <dcterms:modified xsi:type="dcterms:W3CDTF">2023-01-09T10:11:23Z</dcterms:modified>
</cp:coreProperties>
</file>